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8"/>
  </p:notesMasterIdLst>
  <p:sldIdLst>
    <p:sldId id="258" r:id="rId2"/>
    <p:sldId id="262" r:id="rId3"/>
    <p:sldId id="263" r:id="rId4"/>
    <p:sldId id="264" r:id="rId5"/>
    <p:sldId id="256" r:id="rId6"/>
    <p:sldId id="261" r:id="rId7"/>
  </p:sldIdLst>
  <p:sldSz cx="6858000" cy="9906000" type="A4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Sophie Schumacher" initials="SS" lastIdx="2" clrIdx="0">
    <p:extLst>
      <p:ext uri="{19B8F6BF-5375-455C-9EA6-DF929625EA0E}">
        <p15:presenceInfo xmlns:p15="http://schemas.microsoft.com/office/powerpoint/2012/main" userId="e45b75ed953aa031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93D81CF-94F2-401A-BA57-92F5A7B2D0C5}" styleName="Mittlere Formatvorlag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5940675A-B579-460E-94D1-54222C63F5DA}" styleName="Keine Formatvorlage, Tabellenraster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616DA210-FB5B-4158-B5E0-FEB733F419BA}" styleName="Helle Formatvorlag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7" autoAdjust="0"/>
    <p:restoredTop sz="94660"/>
  </p:normalViewPr>
  <p:slideViewPr>
    <p:cSldViewPr snapToGrid="0">
      <p:cViewPr varScale="1">
        <p:scale>
          <a:sx n="105" d="100"/>
          <a:sy n="105" d="100"/>
        </p:scale>
        <p:origin x="6972" y="1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44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44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A61ACC4-1F07-43DC-8B57-A040DF3BC845}" type="datetimeFigureOut">
              <a:rPr lang="de-DE" smtClean="0"/>
              <a:t>20.01.2026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3770313" y="857250"/>
            <a:ext cx="1603375" cy="2314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914400" y="3300413"/>
            <a:ext cx="7315200" cy="270033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6513513"/>
            <a:ext cx="3962400" cy="3444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5180013" y="6513513"/>
            <a:ext cx="3962400" cy="3444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963178A-9C77-46E5-9678-509C6BC1EE0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7498390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de-DE" dirty="0" err="1"/>
              <a:t>Suppl</a:t>
            </a:r>
            <a:r>
              <a:rPr lang="de-DE" dirty="0"/>
              <a:t> Fig 1</a:t>
            </a:r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963178A-9C77-46E5-9678-509C6BC1EE0D}" type="slidenum">
              <a:rPr lang="de-DE" smtClean="0"/>
              <a:t>5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8996921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27E69-E21D-499D-B2EA-8A0468304235}" type="datetimeFigureOut">
              <a:rPr lang="de-DE" smtClean="0"/>
              <a:t>20.01.2026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0CE8EE-4154-4BD9-AC8C-1EF8DC62852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752966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27E69-E21D-499D-B2EA-8A0468304235}" type="datetimeFigureOut">
              <a:rPr lang="de-DE" smtClean="0"/>
              <a:t>20.01.2026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0CE8EE-4154-4BD9-AC8C-1EF8DC62852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203177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27E69-E21D-499D-B2EA-8A0468304235}" type="datetimeFigureOut">
              <a:rPr lang="de-DE" smtClean="0"/>
              <a:t>20.01.2026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0CE8EE-4154-4BD9-AC8C-1EF8DC62852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002643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27E69-E21D-499D-B2EA-8A0468304235}" type="datetimeFigureOut">
              <a:rPr lang="de-DE" smtClean="0"/>
              <a:t>20.01.2026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0CE8EE-4154-4BD9-AC8C-1EF8DC62852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048220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27E69-E21D-499D-B2EA-8A0468304235}" type="datetimeFigureOut">
              <a:rPr lang="de-DE" smtClean="0"/>
              <a:t>20.01.2026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0CE8EE-4154-4BD9-AC8C-1EF8DC62852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177907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27E69-E21D-499D-B2EA-8A0468304235}" type="datetimeFigureOut">
              <a:rPr lang="de-DE" smtClean="0"/>
              <a:t>20.01.2026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0CE8EE-4154-4BD9-AC8C-1EF8DC62852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688224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27E69-E21D-499D-B2EA-8A0468304235}" type="datetimeFigureOut">
              <a:rPr lang="de-DE" smtClean="0"/>
              <a:t>20.01.2026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0CE8EE-4154-4BD9-AC8C-1EF8DC62852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152250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27E69-E21D-499D-B2EA-8A0468304235}" type="datetimeFigureOut">
              <a:rPr lang="de-DE" smtClean="0"/>
              <a:t>20.01.2026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0CE8EE-4154-4BD9-AC8C-1EF8DC62852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374244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27E69-E21D-499D-B2EA-8A0468304235}" type="datetimeFigureOut">
              <a:rPr lang="de-DE" smtClean="0"/>
              <a:t>20.01.2026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0CE8EE-4154-4BD9-AC8C-1EF8DC62852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428603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27E69-E21D-499D-B2EA-8A0468304235}" type="datetimeFigureOut">
              <a:rPr lang="de-DE" smtClean="0"/>
              <a:t>20.01.2026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0CE8EE-4154-4BD9-AC8C-1EF8DC62852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988752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27E69-E21D-499D-B2EA-8A0468304235}" type="datetimeFigureOut">
              <a:rPr lang="de-DE" smtClean="0"/>
              <a:t>20.01.2026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0CE8EE-4154-4BD9-AC8C-1EF8DC62852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932676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6A27E69-E21D-499D-B2EA-8A0468304235}" type="datetimeFigureOut">
              <a:rPr lang="de-DE" smtClean="0"/>
              <a:t>20.01.2026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70CE8EE-4154-4BD9-AC8C-1EF8DC62852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767142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feld 10">
            <a:extLst>
              <a:ext uri="{FF2B5EF4-FFF2-40B4-BE49-F238E27FC236}">
                <a16:creationId xmlns:a16="http://schemas.microsoft.com/office/drawing/2014/main" id="{C3730FA7-EE78-B865-7BC7-219F58481AFD}"/>
              </a:ext>
            </a:extLst>
          </p:cNvPr>
          <p:cNvSpPr txBox="1"/>
          <p:nvPr/>
        </p:nvSpPr>
        <p:spPr>
          <a:xfrm>
            <a:off x="324016" y="5658416"/>
            <a:ext cx="6372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err="1"/>
              <a:t>Suppl</a:t>
            </a:r>
            <a:r>
              <a:rPr lang="de-DE" sz="1200" dirty="0"/>
              <a:t>. </a:t>
            </a:r>
            <a:r>
              <a:rPr lang="de-DE" sz="1200" dirty="0" err="1"/>
              <a:t>Tabl</a:t>
            </a:r>
            <a:r>
              <a:rPr lang="de-DE" sz="1200" dirty="0"/>
              <a:t>. 1: </a:t>
            </a:r>
            <a:r>
              <a:rPr lang="de-DE" sz="1200" dirty="0" err="1"/>
              <a:t>Overview</a:t>
            </a:r>
            <a:r>
              <a:rPr lang="de-DE" sz="1200" dirty="0"/>
              <a:t> </a:t>
            </a:r>
            <a:r>
              <a:rPr lang="de-DE" sz="1200" dirty="0" err="1"/>
              <a:t>over</a:t>
            </a:r>
            <a:r>
              <a:rPr lang="de-DE" sz="1200" dirty="0"/>
              <a:t> HB, </a:t>
            </a:r>
            <a:r>
              <a:rPr lang="de-DE" sz="1200" dirty="0" err="1"/>
              <a:t>Hct</a:t>
            </a:r>
            <a:r>
              <a:rPr lang="de-DE" sz="1200" dirty="0"/>
              <a:t> and </a:t>
            </a:r>
            <a:r>
              <a:rPr lang="de-DE" sz="1200" dirty="0" err="1"/>
              <a:t>Erythrocyte</a:t>
            </a:r>
            <a:r>
              <a:rPr lang="de-DE" sz="1200" dirty="0"/>
              <a:t> </a:t>
            </a:r>
            <a:r>
              <a:rPr lang="de-DE" sz="1200" dirty="0" err="1"/>
              <a:t>counts</a:t>
            </a:r>
            <a:r>
              <a:rPr lang="de-DE" sz="1200" dirty="0"/>
              <a:t> at different time </a:t>
            </a:r>
            <a:r>
              <a:rPr lang="de-DE" sz="1200" dirty="0" err="1"/>
              <a:t>points</a:t>
            </a:r>
            <a:r>
              <a:rPr lang="de-DE" sz="1200" dirty="0"/>
              <a:t> </a:t>
            </a:r>
            <a:r>
              <a:rPr lang="de-DE" sz="1200" dirty="0" err="1"/>
              <a:t>for</a:t>
            </a:r>
            <a:r>
              <a:rPr lang="de-DE" sz="1200" dirty="0"/>
              <a:t> </a:t>
            </a:r>
            <a:r>
              <a:rPr lang="de-DE" sz="1200" dirty="0" err="1"/>
              <a:t>both</a:t>
            </a:r>
            <a:r>
              <a:rPr lang="de-DE" sz="1200" dirty="0"/>
              <a:t> male and </a:t>
            </a:r>
            <a:r>
              <a:rPr lang="de-DE" sz="1200" dirty="0" err="1"/>
              <a:t>female</a:t>
            </a:r>
            <a:r>
              <a:rPr lang="de-DE" sz="1200" dirty="0"/>
              <a:t> </a:t>
            </a:r>
            <a:r>
              <a:rPr lang="de-DE" sz="1200" dirty="0" err="1"/>
              <a:t>patients</a:t>
            </a:r>
            <a:r>
              <a:rPr lang="de-DE" sz="1200" dirty="0"/>
              <a:t>. </a:t>
            </a:r>
          </a:p>
        </p:txBody>
      </p:sp>
      <p:graphicFrame>
        <p:nvGraphicFramePr>
          <p:cNvPr id="3" name="Tabelle 2">
            <a:extLst>
              <a:ext uri="{FF2B5EF4-FFF2-40B4-BE49-F238E27FC236}">
                <a16:creationId xmlns:a16="http://schemas.microsoft.com/office/drawing/2014/main" id="{AFD467B5-3B67-4894-AC50-527BF41EC33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0486548"/>
              </p:ext>
            </p:extLst>
          </p:nvPr>
        </p:nvGraphicFramePr>
        <p:xfrm>
          <a:off x="324017" y="2712379"/>
          <a:ext cx="5981984" cy="2773508"/>
        </p:xfrm>
        <a:graphic>
          <a:graphicData uri="http://schemas.openxmlformats.org/drawingml/2006/table">
            <a:tbl>
              <a:tblPr>
                <a:tableStyleId>{793D81CF-94F2-401A-BA57-92F5A7B2D0C5}</a:tableStyleId>
              </a:tblPr>
              <a:tblGrid>
                <a:gridCol w="177655">
                  <a:extLst>
                    <a:ext uri="{9D8B030D-6E8A-4147-A177-3AD203B41FA5}">
                      <a16:colId xmlns:a16="http://schemas.microsoft.com/office/drawing/2014/main" val="3588205654"/>
                    </a:ext>
                  </a:extLst>
                </a:gridCol>
                <a:gridCol w="386831">
                  <a:extLst>
                    <a:ext uri="{9D8B030D-6E8A-4147-A177-3AD203B41FA5}">
                      <a16:colId xmlns:a16="http://schemas.microsoft.com/office/drawing/2014/main" val="3240667604"/>
                    </a:ext>
                  </a:extLst>
                </a:gridCol>
                <a:gridCol w="243043">
                  <a:extLst>
                    <a:ext uri="{9D8B030D-6E8A-4147-A177-3AD203B41FA5}">
                      <a16:colId xmlns:a16="http://schemas.microsoft.com/office/drawing/2014/main" val="1428855747"/>
                    </a:ext>
                  </a:extLst>
                </a:gridCol>
                <a:gridCol w="470405">
                  <a:extLst>
                    <a:ext uri="{9D8B030D-6E8A-4147-A177-3AD203B41FA5}">
                      <a16:colId xmlns:a16="http://schemas.microsoft.com/office/drawing/2014/main" val="2314642114"/>
                    </a:ext>
                  </a:extLst>
                </a:gridCol>
                <a:gridCol w="470405">
                  <a:extLst>
                    <a:ext uri="{9D8B030D-6E8A-4147-A177-3AD203B41FA5}">
                      <a16:colId xmlns:a16="http://schemas.microsoft.com/office/drawing/2014/main" val="2428955021"/>
                    </a:ext>
                  </a:extLst>
                </a:gridCol>
                <a:gridCol w="470405">
                  <a:extLst>
                    <a:ext uri="{9D8B030D-6E8A-4147-A177-3AD203B41FA5}">
                      <a16:colId xmlns:a16="http://schemas.microsoft.com/office/drawing/2014/main" val="1554420204"/>
                    </a:ext>
                  </a:extLst>
                </a:gridCol>
                <a:gridCol w="470405">
                  <a:extLst>
                    <a:ext uri="{9D8B030D-6E8A-4147-A177-3AD203B41FA5}">
                      <a16:colId xmlns:a16="http://schemas.microsoft.com/office/drawing/2014/main" val="1569077476"/>
                    </a:ext>
                  </a:extLst>
                </a:gridCol>
                <a:gridCol w="470405">
                  <a:extLst>
                    <a:ext uri="{9D8B030D-6E8A-4147-A177-3AD203B41FA5}">
                      <a16:colId xmlns:a16="http://schemas.microsoft.com/office/drawing/2014/main" val="3237187181"/>
                    </a:ext>
                  </a:extLst>
                </a:gridCol>
                <a:gridCol w="470405">
                  <a:extLst>
                    <a:ext uri="{9D8B030D-6E8A-4147-A177-3AD203B41FA5}">
                      <a16:colId xmlns:a16="http://schemas.microsoft.com/office/drawing/2014/main" val="3985809519"/>
                    </a:ext>
                  </a:extLst>
                </a:gridCol>
                <a:gridCol w="470405">
                  <a:extLst>
                    <a:ext uri="{9D8B030D-6E8A-4147-A177-3AD203B41FA5}">
                      <a16:colId xmlns:a16="http://schemas.microsoft.com/office/drawing/2014/main" val="1171927450"/>
                    </a:ext>
                  </a:extLst>
                </a:gridCol>
                <a:gridCol w="470405">
                  <a:extLst>
                    <a:ext uri="{9D8B030D-6E8A-4147-A177-3AD203B41FA5}">
                      <a16:colId xmlns:a16="http://schemas.microsoft.com/office/drawing/2014/main" val="353934764"/>
                    </a:ext>
                  </a:extLst>
                </a:gridCol>
                <a:gridCol w="470405">
                  <a:extLst>
                    <a:ext uri="{9D8B030D-6E8A-4147-A177-3AD203B41FA5}">
                      <a16:colId xmlns:a16="http://schemas.microsoft.com/office/drawing/2014/main" val="2347664201"/>
                    </a:ext>
                  </a:extLst>
                </a:gridCol>
                <a:gridCol w="470405">
                  <a:extLst>
                    <a:ext uri="{9D8B030D-6E8A-4147-A177-3AD203B41FA5}">
                      <a16:colId xmlns:a16="http://schemas.microsoft.com/office/drawing/2014/main" val="1557635518"/>
                    </a:ext>
                  </a:extLst>
                </a:gridCol>
                <a:gridCol w="470405">
                  <a:extLst>
                    <a:ext uri="{9D8B030D-6E8A-4147-A177-3AD203B41FA5}">
                      <a16:colId xmlns:a16="http://schemas.microsoft.com/office/drawing/2014/main" val="2780847319"/>
                    </a:ext>
                  </a:extLst>
                </a:gridCol>
              </a:tblGrid>
              <a:tr h="133022"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de-DE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 gridSpan="5">
                  <a:txBody>
                    <a:bodyPr/>
                    <a:lstStyle/>
                    <a:p>
                      <a:pPr algn="ctr" fontAlgn="b"/>
                      <a:r>
                        <a:rPr lang="de-DE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le</a:t>
                      </a:r>
                      <a:endParaRPr lang="de-DE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gridSpan="6">
                  <a:txBody>
                    <a:bodyPr/>
                    <a:lstStyle/>
                    <a:p>
                      <a:pPr algn="ctr" fontAlgn="b"/>
                      <a:r>
                        <a:rPr lang="de-DE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emale</a:t>
                      </a:r>
                      <a:endParaRPr lang="de-DE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de-DE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1" marR="6651" marT="665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60064256"/>
                  </a:ext>
                </a:extLst>
              </a:tr>
              <a:tr h="226137"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de-DE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b"/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de-DE" sz="600" b="1" u="none" strike="noStrike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Standard </a:t>
                      </a:r>
                      <a:r>
                        <a:rPr lang="de-DE" sz="600" b="1" u="none" strike="noStrike" kern="1200" dirty="0" err="1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value</a:t>
                      </a:r>
                      <a:endParaRPr lang="de-DE" sz="600" b="1" u="none" strike="noStrike" kern="1200" dirty="0">
                        <a:solidFill>
                          <a:schemeClr val="dk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6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endParaRPr lang="de-DE" sz="600" b="1" i="0" u="none" strike="noStrike" dirty="0">
                        <a:solidFill>
                          <a:srgbClr val="333399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6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nimum</a:t>
                      </a:r>
                      <a:endParaRPr lang="de-DE" sz="600" b="1" i="0" u="none" strike="noStrike" dirty="0">
                        <a:solidFill>
                          <a:srgbClr val="333399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6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ximum</a:t>
                      </a:r>
                      <a:endParaRPr lang="de-DE" sz="600" b="1" i="0" u="none" strike="noStrike" dirty="0">
                        <a:solidFill>
                          <a:srgbClr val="333399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600" b="1" u="none" strike="noStrike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ean</a:t>
                      </a: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600" b="1" u="none" strike="noStrike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Standard Deviation</a:t>
                      </a:r>
                    </a:p>
                  </a:txBody>
                  <a:tcPr marL="6651" marR="6651" marT="6651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andard </a:t>
                      </a:r>
                      <a:r>
                        <a:rPr lang="de-DE" sz="6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alue</a:t>
                      </a:r>
                      <a:endParaRPr lang="de-DE" sz="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6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endParaRPr lang="de-DE" sz="600" b="1" i="0" u="none" strike="noStrike" dirty="0">
                        <a:solidFill>
                          <a:srgbClr val="333399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6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nimum</a:t>
                      </a:r>
                      <a:endParaRPr lang="de-DE" sz="600" b="1" i="0" u="none" strike="noStrike" dirty="0">
                        <a:solidFill>
                          <a:srgbClr val="333399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6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ximum</a:t>
                      </a:r>
                      <a:endParaRPr lang="de-DE" sz="600" b="1" i="0" u="none" strike="noStrike" dirty="0">
                        <a:solidFill>
                          <a:srgbClr val="333399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600" b="1" u="none" strike="noStrike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ean</a:t>
                      </a: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600" b="1" u="none" strike="noStrike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Standard Deviation</a:t>
                      </a:r>
                    </a:p>
                  </a:txBody>
                  <a:tcPr marL="6651" marR="6651" marT="6651" marB="0" anchor="ctr"/>
                </a:tc>
                <a:extLst>
                  <a:ext uri="{0D108BD9-81ED-4DB2-BD59-A6C34878D82A}">
                    <a16:rowId xmlns:a16="http://schemas.microsoft.com/office/drawing/2014/main" val="1923615961"/>
                  </a:ext>
                </a:extLst>
              </a:tr>
              <a:tr h="133022">
                <a:tc rowSpan="6">
                  <a:txBody>
                    <a:bodyPr/>
                    <a:lstStyle/>
                    <a:p>
                      <a:pPr algn="ctr" fontAlgn="ctr"/>
                      <a:r>
                        <a:rPr lang="de-DE" sz="8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moglobin</a:t>
                      </a:r>
                      <a:endParaRPr lang="de-DE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vert="vert270" anchor="ctr"/>
                </a:tc>
                <a:tc rowSpan="6">
                  <a:txBody>
                    <a:bodyPr/>
                    <a:lstStyle/>
                    <a:p>
                      <a:pPr algn="ctr" fontAlgn="ctr"/>
                      <a:r>
                        <a:rPr lang="de-DE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gt; 13mg/dl</a:t>
                      </a:r>
                    </a:p>
                  </a:txBody>
                  <a:tcPr marL="6651" marR="6651" marT="6651" marB="0" vert="vert27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L</a:t>
                      </a:r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6</a:t>
                      </a:r>
                      <a:endParaRPr lang="de-DE" sz="6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,10</a:t>
                      </a:r>
                      <a:endParaRPr lang="de-DE" sz="6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,80</a:t>
                      </a:r>
                      <a:endParaRPr lang="de-DE" sz="6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,3969</a:t>
                      </a:r>
                      <a:endParaRPr lang="de-DE" sz="6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,33623</a:t>
                      </a:r>
                      <a:endParaRPr lang="de-DE" sz="6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 rowSpan="6">
                  <a:txBody>
                    <a:bodyPr/>
                    <a:lstStyle/>
                    <a:p>
                      <a:pPr algn="ctr" fontAlgn="t"/>
                      <a:r>
                        <a:rPr lang="de-DE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gt;12mg/dl</a:t>
                      </a:r>
                    </a:p>
                  </a:txBody>
                  <a:tcPr marL="6651" marR="6651" marT="6651" marB="0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,60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,10</a:t>
                      </a:r>
                      <a:endParaRPr lang="de-DE" sz="6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,5767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,04296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extLst>
                  <a:ext uri="{0D108BD9-81ED-4DB2-BD59-A6C34878D82A}">
                    <a16:rowId xmlns:a16="http://schemas.microsoft.com/office/drawing/2014/main" val="1011445766"/>
                  </a:ext>
                </a:extLst>
              </a:tr>
              <a:tr h="133022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1</a:t>
                      </a:r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,10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,60</a:t>
                      </a:r>
                      <a:endParaRPr lang="de-DE" sz="6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,5880</a:t>
                      </a:r>
                      <a:endParaRPr lang="de-DE" sz="6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,41408</a:t>
                      </a:r>
                      <a:endParaRPr lang="de-DE" sz="6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 vMerge="1">
                  <a:txBody>
                    <a:bodyPr/>
                    <a:lstStyle/>
                    <a:p>
                      <a:pPr algn="ctr" fontAlgn="t"/>
                      <a:endParaRPr lang="de-DE" sz="6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651" marR="6651" marT="665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,30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,90</a:t>
                      </a:r>
                      <a:endParaRPr lang="de-DE" sz="6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,8583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97183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extLst>
                  <a:ext uri="{0D108BD9-81ED-4DB2-BD59-A6C34878D82A}">
                    <a16:rowId xmlns:a16="http://schemas.microsoft.com/office/drawing/2014/main" val="3746517650"/>
                  </a:ext>
                </a:extLst>
              </a:tr>
              <a:tr h="133022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2</a:t>
                      </a:r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,20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,40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,1455</a:t>
                      </a:r>
                      <a:endParaRPr lang="de-DE" sz="6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93014</a:t>
                      </a:r>
                      <a:endParaRPr lang="de-DE" sz="6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 vMerge="1">
                  <a:txBody>
                    <a:bodyPr/>
                    <a:lstStyle/>
                    <a:p>
                      <a:pPr algn="ctr" fontAlgn="t"/>
                      <a:endParaRPr lang="de-DE" sz="6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651" marR="6651" marT="665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de-DE" sz="6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,00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,20</a:t>
                      </a:r>
                      <a:endParaRPr lang="de-DE" sz="6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,7833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25469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extLst>
                  <a:ext uri="{0D108BD9-81ED-4DB2-BD59-A6C34878D82A}">
                    <a16:rowId xmlns:a16="http://schemas.microsoft.com/office/drawing/2014/main" val="2434338771"/>
                  </a:ext>
                </a:extLst>
              </a:tr>
              <a:tr h="133022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3</a:t>
                      </a:r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  <a:endParaRPr lang="de-DE" sz="6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,30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,90</a:t>
                      </a:r>
                      <a:endParaRPr lang="de-DE" sz="6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,6900</a:t>
                      </a:r>
                      <a:endParaRPr lang="de-DE" sz="6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,17277</a:t>
                      </a:r>
                      <a:endParaRPr lang="de-DE" sz="6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 vMerge="1">
                  <a:txBody>
                    <a:bodyPr/>
                    <a:lstStyle/>
                    <a:p>
                      <a:pPr algn="ctr" fontAlgn="t"/>
                      <a:endParaRPr lang="de-DE" sz="6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651" marR="6651" marT="665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de-DE" sz="6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,10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,70</a:t>
                      </a:r>
                      <a:endParaRPr lang="de-DE" sz="6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,2500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18439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extLst>
                  <a:ext uri="{0D108BD9-81ED-4DB2-BD59-A6C34878D82A}">
                    <a16:rowId xmlns:a16="http://schemas.microsoft.com/office/drawing/2014/main" val="3961681788"/>
                  </a:ext>
                </a:extLst>
              </a:tr>
              <a:tr h="133022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OT</a:t>
                      </a:r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,10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,10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,4909</a:t>
                      </a:r>
                      <a:endParaRPr lang="de-DE" sz="6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,40434</a:t>
                      </a:r>
                      <a:endParaRPr lang="de-DE" sz="6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 vMerge="1">
                  <a:txBody>
                    <a:bodyPr/>
                    <a:lstStyle/>
                    <a:p>
                      <a:pPr algn="ctr" fontAlgn="t"/>
                      <a:endParaRPr lang="de-DE" sz="6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651" marR="6651" marT="665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de-DE" sz="6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,30</a:t>
                      </a:r>
                      <a:endParaRPr lang="de-DE" sz="6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,80</a:t>
                      </a:r>
                      <a:endParaRPr lang="de-DE" sz="6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,7600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20955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extLst>
                  <a:ext uri="{0D108BD9-81ED-4DB2-BD59-A6C34878D82A}">
                    <a16:rowId xmlns:a16="http://schemas.microsoft.com/office/drawing/2014/main" val="204250234"/>
                  </a:ext>
                </a:extLst>
              </a:tr>
              <a:tr h="139673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U</a:t>
                      </a:r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,00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,80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,7000</a:t>
                      </a:r>
                      <a:endParaRPr lang="de-DE" sz="6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,08761</a:t>
                      </a:r>
                      <a:endParaRPr lang="de-DE" sz="6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 vMerge="1">
                  <a:txBody>
                    <a:bodyPr/>
                    <a:lstStyle/>
                    <a:p>
                      <a:pPr algn="ctr" fontAlgn="t"/>
                      <a:endParaRPr lang="de-DE" sz="6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651" marR="6651" marT="665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,20</a:t>
                      </a:r>
                      <a:endParaRPr lang="de-DE" sz="6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,50</a:t>
                      </a:r>
                      <a:endParaRPr lang="de-DE" sz="6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,3500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21213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extLst>
                  <a:ext uri="{0D108BD9-81ED-4DB2-BD59-A6C34878D82A}">
                    <a16:rowId xmlns:a16="http://schemas.microsoft.com/office/drawing/2014/main" val="3331589430"/>
                  </a:ext>
                </a:extLst>
              </a:tr>
              <a:tr h="133022">
                <a:tc rowSpan="6">
                  <a:txBody>
                    <a:bodyPr/>
                    <a:lstStyle/>
                    <a:p>
                      <a:pPr algn="ctr" fontAlgn="ctr"/>
                      <a:r>
                        <a:rPr lang="de-DE" sz="8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matokrit</a:t>
                      </a:r>
                      <a:endParaRPr lang="de-DE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vert="vert270" anchor="ctr"/>
                </a:tc>
                <a:tc rowSpan="6">
                  <a:txBody>
                    <a:bodyPr/>
                    <a:lstStyle/>
                    <a:p>
                      <a:pPr algn="ctr" fontAlgn="ctr"/>
                      <a:r>
                        <a:rPr lang="de-DE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gt; 0.49</a:t>
                      </a:r>
                    </a:p>
                  </a:txBody>
                  <a:tcPr marL="6651" marR="6651" marT="6651" marB="0" vert="vert27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L</a:t>
                      </a:r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6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19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52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3659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06446</a:t>
                      </a:r>
                      <a:endParaRPr lang="de-DE" sz="6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 rowSpan="6">
                  <a:txBody>
                    <a:bodyPr/>
                    <a:lstStyle/>
                    <a:p>
                      <a:pPr algn="ctr" fontAlgn="t"/>
                      <a:r>
                        <a:rPr lang="de-DE" sz="6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&gt; 0.37</a:t>
                      </a:r>
                    </a:p>
                  </a:txBody>
                  <a:tcPr marL="6651" marR="6651" marT="6651" marB="0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22</a:t>
                      </a:r>
                      <a:endParaRPr lang="de-DE" sz="6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46</a:t>
                      </a:r>
                      <a:endParaRPr lang="de-DE" sz="6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3443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05792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extLst>
                  <a:ext uri="{0D108BD9-81ED-4DB2-BD59-A6C34878D82A}">
                    <a16:rowId xmlns:a16="http://schemas.microsoft.com/office/drawing/2014/main" val="761555266"/>
                  </a:ext>
                </a:extLst>
              </a:tr>
              <a:tr h="133022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1</a:t>
                      </a:r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28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51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3706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06422</a:t>
                      </a:r>
                      <a:endParaRPr lang="de-DE" sz="6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 vMerge="1">
                  <a:txBody>
                    <a:bodyPr/>
                    <a:lstStyle/>
                    <a:p>
                      <a:pPr algn="ctr" fontAlgn="t"/>
                      <a:endParaRPr lang="de-DE" sz="6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651" marR="6651" marT="665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23</a:t>
                      </a:r>
                      <a:endParaRPr lang="de-DE" sz="6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40</a:t>
                      </a:r>
                      <a:endParaRPr lang="de-DE" sz="6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3262</a:t>
                      </a:r>
                      <a:endParaRPr lang="de-DE" sz="6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05436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extLst>
                  <a:ext uri="{0D108BD9-81ED-4DB2-BD59-A6C34878D82A}">
                    <a16:rowId xmlns:a16="http://schemas.microsoft.com/office/drawing/2014/main" val="3403123119"/>
                  </a:ext>
                </a:extLst>
              </a:tr>
              <a:tr h="133022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2</a:t>
                      </a:r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23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47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3525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05787</a:t>
                      </a:r>
                      <a:endParaRPr lang="de-DE" sz="6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 vMerge="1">
                  <a:txBody>
                    <a:bodyPr/>
                    <a:lstStyle/>
                    <a:p>
                      <a:pPr algn="ctr" fontAlgn="t"/>
                      <a:endParaRPr lang="de-DE" sz="6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651" marR="6651" marT="665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27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39</a:t>
                      </a:r>
                      <a:endParaRPr lang="de-DE" sz="6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3198</a:t>
                      </a:r>
                      <a:endParaRPr lang="de-DE" sz="6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03550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extLst>
                  <a:ext uri="{0D108BD9-81ED-4DB2-BD59-A6C34878D82A}">
                    <a16:rowId xmlns:a16="http://schemas.microsoft.com/office/drawing/2014/main" val="2259619336"/>
                  </a:ext>
                </a:extLst>
              </a:tr>
              <a:tr h="133022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3</a:t>
                      </a:r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18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44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3412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06305</a:t>
                      </a:r>
                      <a:endParaRPr lang="de-DE" sz="6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 vMerge="1">
                  <a:txBody>
                    <a:bodyPr/>
                    <a:lstStyle/>
                    <a:p>
                      <a:pPr algn="ctr" fontAlgn="t"/>
                      <a:endParaRPr lang="de-DE" sz="6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651" marR="6651" marT="665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25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38</a:t>
                      </a:r>
                      <a:endParaRPr lang="de-DE" sz="6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3044</a:t>
                      </a:r>
                      <a:endParaRPr lang="de-DE" sz="6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04134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extLst>
                  <a:ext uri="{0D108BD9-81ED-4DB2-BD59-A6C34878D82A}">
                    <a16:rowId xmlns:a16="http://schemas.microsoft.com/office/drawing/2014/main" val="700682731"/>
                  </a:ext>
                </a:extLst>
              </a:tr>
              <a:tr h="133022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OT</a:t>
                      </a:r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23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48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3353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06334</a:t>
                      </a:r>
                      <a:endParaRPr lang="de-DE" sz="6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 vMerge="1">
                  <a:txBody>
                    <a:bodyPr/>
                    <a:lstStyle/>
                    <a:p>
                      <a:pPr algn="ctr" fontAlgn="t"/>
                      <a:endParaRPr lang="de-DE" sz="6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651" marR="6651" marT="665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23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33</a:t>
                      </a:r>
                      <a:endParaRPr lang="de-DE" sz="6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2844</a:t>
                      </a:r>
                      <a:endParaRPr lang="de-DE" sz="6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04266</a:t>
                      </a:r>
                      <a:endParaRPr lang="de-DE" sz="6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extLst>
                  <a:ext uri="{0D108BD9-81ED-4DB2-BD59-A6C34878D82A}">
                    <a16:rowId xmlns:a16="http://schemas.microsoft.com/office/drawing/2014/main" val="1814682240"/>
                  </a:ext>
                </a:extLst>
              </a:tr>
              <a:tr h="139673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U</a:t>
                      </a:r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19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39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3020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09092</a:t>
                      </a:r>
                      <a:endParaRPr lang="de-DE" sz="6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 vMerge="1">
                  <a:txBody>
                    <a:bodyPr/>
                    <a:lstStyle/>
                    <a:p>
                      <a:pPr algn="ctr" fontAlgn="t"/>
                      <a:endParaRPr lang="de-DE" sz="6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651" marR="6651" marT="665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33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33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3310</a:t>
                      </a:r>
                      <a:endParaRPr lang="de-DE" sz="6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00424</a:t>
                      </a:r>
                      <a:endParaRPr lang="de-DE" sz="6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extLst>
                  <a:ext uri="{0D108BD9-81ED-4DB2-BD59-A6C34878D82A}">
                    <a16:rowId xmlns:a16="http://schemas.microsoft.com/office/drawing/2014/main" val="1459797550"/>
                  </a:ext>
                </a:extLst>
              </a:tr>
              <a:tr h="133022">
                <a:tc rowSpan="6">
                  <a:txBody>
                    <a:bodyPr/>
                    <a:lstStyle/>
                    <a:p>
                      <a:pPr algn="ctr" fontAlgn="ctr"/>
                      <a:r>
                        <a:rPr lang="de-DE" sz="8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rythrocytes</a:t>
                      </a:r>
                      <a:endParaRPr lang="de-DE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vert="vert270" anchor="ctr"/>
                </a:tc>
                <a:tc rowSpan="6">
                  <a:txBody>
                    <a:bodyPr/>
                    <a:lstStyle/>
                    <a:p>
                      <a:pPr algn="ctr" fontAlgn="ctr"/>
                      <a:r>
                        <a:rPr lang="de-DE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gt; 5.6 </a:t>
                      </a:r>
                      <a:r>
                        <a:rPr lang="de-DE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s</a:t>
                      </a:r>
                      <a:r>
                        <a:rPr lang="de-DE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</a:t>
                      </a:r>
                      <a:r>
                        <a:rPr lang="de-DE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L</a:t>
                      </a:r>
                      <a:endParaRPr lang="de-DE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vert="vert27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L</a:t>
                      </a:r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6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,10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,00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,1052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80307</a:t>
                      </a:r>
                      <a:endParaRPr lang="de-DE" sz="6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 rowSpan="6">
                  <a:txBody>
                    <a:bodyPr/>
                    <a:lstStyle/>
                    <a:p>
                      <a:pPr algn="ctr" fontAlgn="t"/>
                      <a:r>
                        <a:rPr lang="de-DE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gt; 4.0 </a:t>
                      </a:r>
                      <a:r>
                        <a:rPr lang="de-DE" sz="6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s</a:t>
                      </a:r>
                      <a:r>
                        <a:rPr lang="de-DE" sz="6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</a:t>
                      </a:r>
                      <a:r>
                        <a:rPr lang="de-DE" sz="6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L</a:t>
                      </a:r>
                      <a:endParaRPr lang="de-DE" sz="6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,30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,90</a:t>
                      </a:r>
                      <a:endParaRPr lang="de-DE" sz="6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,8100</a:t>
                      </a:r>
                      <a:endParaRPr lang="de-DE" sz="6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61883</a:t>
                      </a:r>
                      <a:endParaRPr lang="de-DE" sz="6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extLst>
                  <a:ext uri="{0D108BD9-81ED-4DB2-BD59-A6C34878D82A}">
                    <a16:rowId xmlns:a16="http://schemas.microsoft.com/office/drawing/2014/main" val="134261004"/>
                  </a:ext>
                </a:extLst>
              </a:tr>
              <a:tr h="133022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1</a:t>
                      </a:r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,00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,30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,2240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87525</a:t>
                      </a:r>
                      <a:endParaRPr lang="de-DE" sz="6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 vMerge="1">
                  <a:txBody>
                    <a:bodyPr/>
                    <a:lstStyle/>
                    <a:p>
                      <a:pPr algn="ctr" fontAlgn="t"/>
                      <a:endParaRPr lang="de-DE" sz="6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651" marR="6651" marT="665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,60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,30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,5667</a:t>
                      </a:r>
                      <a:endParaRPr lang="de-DE" sz="6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63006</a:t>
                      </a:r>
                      <a:endParaRPr lang="de-DE" sz="6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extLst>
                  <a:ext uri="{0D108BD9-81ED-4DB2-BD59-A6C34878D82A}">
                    <a16:rowId xmlns:a16="http://schemas.microsoft.com/office/drawing/2014/main" val="3478435598"/>
                  </a:ext>
                </a:extLst>
              </a:tr>
              <a:tr h="133022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2</a:t>
                      </a:r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,50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,70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,0273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77225</a:t>
                      </a:r>
                      <a:endParaRPr lang="de-DE" sz="6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 vMerge="1">
                  <a:txBody>
                    <a:bodyPr/>
                    <a:lstStyle/>
                    <a:p>
                      <a:pPr algn="ctr" fontAlgn="t"/>
                      <a:endParaRPr lang="de-DE" sz="6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651" marR="6651" marT="665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,90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,30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,5417</a:t>
                      </a:r>
                      <a:endParaRPr lang="de-DE" sz="6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40330</a:t>
                      </a:r>
                      <a:endParaRPr lang="de-DE" sz="6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extLst>
                  <a:ext uri="{0D108BD9-81ED-4DB2-BD59-A6C34878D82A}">
                    <a16:rowId xmlns:a16="http://schemas.microsoft.com/office/drawing/2014/main" val="3744489060"/>
                  </a:ext>
                </a:extLst>
              </a:tr>
              <a:tr h="133022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3</a:t>
                      </a:r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,10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,20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,9000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71745</a:t>
                      </a:r>
                      <a:endParaRPr lang="de-DE" sz="6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 vMerge="1">
                  <a:txBody>
                    <a:bodyPr/>
                    <a:lstStyle/>
                    <a:p>
                      <a:pPr algn="ctr" fontAlgn="t"/>
                      <a:endParaRPr lang="de-DE" sz="6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651" marR="6651" marT="665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,60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,10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,3300</a:t>
                      </a:r>
                      <a:endParaRPr lang="de-DE" sz="6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49900</a:t>
                      </a:r>
                      <a:endParaRPr lang="de-DE" sz="6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extLst>
                  <a:ext uri="{0D108BD9-81ED-4DB2-BD59-A6C34878D82A}">
                    <a16:rowId xmlns:a16="http://schemas.microsoft.com/office/drawing/2014/main" val="3172264445"/>
                  </a:ext>
                </a:extLst>
              </a:tr>
              <a:tr h="133022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OT</a:t>
                      </a:r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,40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,80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,7636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85275</a:t>
                      </a:r>
                      <a:endParaRPr lang="de-DE" sz="6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 vMerge="1">
                  <a:txBody>
                    <a:bodyPr/>
                    <a:lstStyle/>
                    <a:p>
                      <a:pPr algn="ctr" fontAlgn="t"/>
                      <a:endParaRPr lang="de-DE" sz="6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651" marR="6651" marT="665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,50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,50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,1200</a:t>
                      </a:r>
                      <a:endParaRPr lang="de-DE" sz="6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44944</a:t>
                      </a:r>
                      <a:endParaRPr lang="de-DE" sz="6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extLst>
                  <a:ext uri="{0D108BD9-81ED-4DB2-BD59-A6C34878D82A}">
                    <a16:rowId xmlns:a16="http://schemas.microsoft.com/office/drawing/2014/main" val="2831361360"/>
                  </a:ext>
                </a:extLst>
              </a:tr>
              <a:tr h="139673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U</a:t>
                      </a:r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,10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,60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,4750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10868</a:t>
                      </a:r>
                      <a:endParaRPr lang="de-DE" sz="6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 vMerge="1">
                  <a:txBody>
                    <a:bodyPr/>
                    <a:lstStyle/>
                    <a:p>
                      <a:pPr algn="ctr" fontAlgn="t"/>
                      <a:endParaRPr lang="de-DE" sz="6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651" marR="6651" marT="665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,40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,70</a:t>
                      </a:r>
                      <a:endParaRPr lang="de-DE" sz="600" b="0" i="0" u="none" strike="noStrike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,5500</a:t>
                      </a:r>
                      <a:endParaRPr lang="de-DE" sz="6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de-DE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21213</a:t>
                      </a:r>
                      <a:endParaRPr lang="de-DE" sz="600" b="0" i="0" u="none" strike="noStrike" dirty="0">
                        <a:solidFill>
                          <a:srgbClr val="9933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651" marR="6651" marT="6651" marB="0" anchor="ctr"/>
                </a:tc>
                <a:extLst>
                  <a:ext uri="{0D108BD9-81ED-4DB2-BD59-A6C34878D82A}">
                    <a16:rowId xmlns:a16="http://schemas.microsoft.com/office/drawing/2014/main" val="25873498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13609538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feld 4">
            <a:extLst>
              <a:ext uri="{FF2B5EF4-FFF2-40B4-BE49-F238E27FC236}">
                <a16:creationId xmlns:a16="http://schemas.microsoft.com/office/drawing/2014/main" id="{9E6A7628-8B1B-87F8-226A-8C0A6D21EB38}"/>
              </a:ext>
            </a:extLst>
          </p:cNvPr>
          <p:cNvSpPr txBox="1"/>
          <p:nvPr/>
        </p:nvSpPr>
        <p:spPr>
          <a:xfrm>
            <a:off x="390002" y="4331365"/>
            <a:ext cx="6372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err="1"/>
              <a:t>Suppl</a:t>
            </a:r>
            <a:r>
              <a:rPr lang="de-DE" sz="1200" dirty="0"/>
              <a:t>. </a:t>
            </a:r>
            <a:r>
              <a:rPr lang="de-DE" sz="1200" dirty="0" err="1"/>
              <a:t>Tabl</a:t>
            </a:r>
            <a:r>
              <a:rPr lang="de-DE" sz="1200" dirty="0"/>
              <a:t>. 2: </a:t>
            </a:r>
            <a:r>
              <a:rPr lang="de-DE" sz="1200" dirty="0" err="1"/>
              <a:t>Overview</a:t>
            </a:r>
            <a:r>
              <a:rPr lang="de-DE" sz="1200" dirty="0"/>
              <a:t> </a:t>
            </a:r>
            <a:r>
              <a:rPr lang="de-DE" sz="1200" dirty="0" err="1"/>
              <a:t>over</a:t>
            </a:r>
            <a:r>
              <a:rPr lang="de-DE" sz="1200" dirty="0"/>
              <a:t> </a:t>
            </a:r>
            <a:r>
              <a:rPr lang="de-DE" sz="1200" dirty="0" err="1"/>
              <a:t>results</a:t>
            </a:r>
            <a:r>
              <a:rPr lang="de-DE" sz="1200" dirty="0"/>
              <a:t> </a:t>
            </a:r>
            <a:r>
              <a:rPr lang="de-DE" sz="1200" dirty="0" err="1"/>
              <a:t>of</a:t>
            </a:r>
            <a:r>
              <a:rPr lang="de-DE" sz="1200" dirty="0"/>
              <a:t> </a:t>
            </a:r>
            <a:r>
              <a:rPr lang="de-DE" sz="1200" dirty="0" err="1"/>
              <a:t>chi-squared</a:t>
            </a:r>
            <a:r>
              <a:rPr lang="de-DE" sz="1200" dirty="0"/>
              <a:t> </a:t>
            </a:r>
            <a:r>
              <a:rPr lang="de-DE" sz="1200" dirty="0" err="1"/>
              <a:t>test</a:t>
            </a:r>
            <a:r>
              <a:rPr lang="de-DE" sz="1200" dirty="0"/>
              <a:t> </a:t>
            </a:r>
            <a:r>
              <a:rPr lang="en-US" sz="1200" dirty="0"/>
              <a:t>for data of patients with TSA´T below 20% (A). Significant values are marked by bold lettering and yellow color. N= number of patients, EOT= end of radiotherapy. * =at least 1 cell has an expected frequency of less than 5 in the analysis</a:t>
            </a:r>
            <a:endParaRPr lang="de-DE" sz="1200" dirty="0"/>
          </a:p>
        </p:txBody>
      </p:sp>
      <p:sp>
        <p:nvSpPr>
          <p:cNvPr id="6" name="Textfeld 5">
            <a:extLst>
              <a:ext uri="{FF2B5EF4-FFF2-40B4-BE49-F238E27FC236}">
                <a16:creationId xmlns:a16="http://schemas.microsoft.com/office/drawing/2014/main" id="{7186999B-6A24-5FD1-C3E2-EE3E260345C2}"/>
              </a:ext>
            </a:extLst>
          </p:cNvPr>
          <p:cNvSpPr txBox="1"/>
          <p:nvPr/>
        </p:nvSpPr>
        <p:spPr>
          <a:xfrm>
            <a:off x="0" y="1719500"/>
            <a:ext cx="4776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b="1" dirty="0"/>
              <a:t>A</a:t>
            </a:r>
          </a:p>
        </p:txBody>
      </p:sp>
      <p:graphicFrame>
        <p:nvGraphicFramePr>
          <p:cNvPr id="3" name="Tabelle 2">
            <a:extLst>
              <a:ext uri="{FF2B5EF4-FFF2-40B4-BE49-F238E27FC236}">
                <a16:creationId xmlns:a16="http://schemas.microsoft.com/office/drawing/2014/main" id="{8879E612-E379-4BC1-9229-744C14A522D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29065693"/>
              </p:ext>
            </p:extLst>
          </p:nvPr>
        </p:nvGraphicFramePr>
        <p:xfrm>
          <a:off x="471487" y="2419285"/>
          <a:ext cx="5915025" cy="1581627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771525">
                  <a:extLst>
                    <a:ext uri="{9D8B030D-6E8A-4147-A177-3AD203B41FA5}">
                      <a16:colId xmlns:a16="http://schemas.microsoft.com/office/drawing/2014/main" val="3883942036"/>
                    </a:ext>
                  </a:extLst>
                </a:gridCol>
                <a:gridCol w="514350">
                  <a:extLst>
                    <a:ext uri="{9D8B030D-6E8A-4147-A177-3AD203B41FA5}">
                      <a16:colId xmlns:a16="http://schemas.microsoft.com/office/drawing/2014/main" val="2907129170"/>
                    </a:ext>
                  </a:extLst>
                </a:gridCol>
                <a:gridCol w="514350">
                  <a:extLst>
                    <a:ext uri="{9D8B030D-6E8A-4147-A177-3AD203B41FA5}">
                      <a16:colId xmlns:a16="http://schemas.microsoft.com/office/drawing/2014/main" val="1118131678"/>
                    </a:ext>
                  </a:extLst>
                </a:gridCol>
                <a:gridCol w="514350">
                  <a:extLst>
                    <a:ext uri="{9D8B030D-6E8A-4147-A177-3AD203B41FA5}">
                      <a16:colId xmlns:a16="http://schemas.microsoft.com/office/drawing/2014/main" val="3135475395"/>
                    </a:ext>
                  </a:extLst>
                </a:gridCol>
                <a:gridCol w="514350">
                  <a:extLst>
                    <a:ext uri="{9D8B030D-6E8A-4147-A177-3AD203B41FA5}">
                      <a16:colId xmlns:a16="http://schemas.microsoft.com/office/drawing/2014/main" val="3794309266"/>
                    </a:ext>
                  </a:extLst>
                </a:gridCol>
                <a:gridCol w="514350">
                  <a:extLst>
                    <a:ext uri="{9D8B030D-6E8A-4147-A177-3AD203B41FA5}">
                      <a16:colId xmlns:a16="http://schemas.microsoft.com/office/drawing/2014/main" val="892051682"/>
                    </a:ext>
                  </a:extLst>
                </a:gridCol>
                <a:gridCol w="514350">
                  <a:extLst>
                    <a:ext uri="{9D8B030D-6E8A-4147-A177-3AD203B41FA5}">
                      <a16:colId xmlns:a16="http://schemas.microsoft.com/office/drawing/2014/main" val="888910946"/>
                    </a:ext>
                  </a:extLst>
                </a:gridCol>
                <a:gridCol w="514350">
                  <a:extLst>
                    <a:ext uri="{9D8B030D-6E8A-4147-A177-3AD203B41FA5}">
                      <a16:colId xmlns:a16="http://schemas.microsoft.com/office/drawing/2014/main" val="3505601122"/>
                    </a:ext>
                  </a:extLst>
                </a:gridCol>
                <a:gridCol w="514350">
                  <a:extLst>
                    <a:ext uri="{9D8B030D-6E8A-4147-A177-3AD203B41FA5}">
                      <a16:colId xmlns:a16="http://schemas.microsoft.com/office/drawing/2014/main" val="3829320796"/>
                    </a:ext>
                  </a:extLst>
                </a:gridCol>
                <a:gridCol w="514350">
                  <a:extLst>
                    <a:ext uri="{9D8B030D-6E8A-4147-A177-3AD203B41FA5}">
                      <a16:colId xmlns:a16="http://schemas.microsoft.com/office/drawing/2014/main" val="2274623625"/>
                    </a:ext>
                  </a:extLst>
                </a:gridCol>
                <a:gridCol w="514350">
                  <a:extLst>
                    <a:ext uri="{9D8B030D-6E8A-4147-A177-3AD203B41FA5}">
                      <a16:colId xmlns:a16="http://schemas.microsoft.com/office/drawing/2014/main" val="1725420060"/>
                    </a:ext>
                  </a:extLst>
                </a:gridCol>
              </a:tblGrid>
              <a:tr h="135017">
                <a:tc rowSpan="3">
                  <a:txBody>
                    <a:bodyPr/>
                    <a:lstStyle/>
                    <a:p>
                      <a:pPr algn="ctr" rtl="0" fontAlgn="b"/>
                      <a:r>
                        <a:rPr lang="de-DE" sz="700" u="none" strike="noStrike">
                          <a:effectLst/>
                        </a:rPr>
                        <a:t> 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429" marR="6429" marT="6429" marB="0" anchor="b"/>
                </a:tc>
                <a:tc gridSpan="10">
                  <a:txBody>
                    <a:bodyPr/>
                    <a:lstStyle/>
                    <a:p>
                      <a:pPr algn="ctr" rtl="0" fontAlgn="b"/>
                      <a:r>
                        <a:rPr lang="de-DE" sz="700" u="none" strike="noStrike">
                          <a:effectLst/>
                        </a:rPr>
                        <a:t>TSAT below 20%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429" marR="6429" marT="6429" marB="0" anchor="b"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29834781"/>
                  </a:ext>
                </a:extLst>
              </a:tr>
              <a:tr h="135017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gridSpan="5">
                  <a:txBody>
                    <a:bodyPr/>
                    <a:lstStyle/>
                    <a:p>
                      <a:pPr algn="ctr" rtl="0" fontAlgn="b"/>
                      <a:r>
                        <a:rPr lang="de-DE" sz="700" u="none" strike="noStrike">
                          <a:effectLst/>
                        </a:rPr>
                        <a:t>Baseline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429" marR="6429" marT="6429" marB="0" anchor="b"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gridSpan="5">
                  <a:txBody>
                    <a:bodyPr/>
                    <a:lstStyle/>
                    <a:p>
                      <a:pPr algn="ctr" rtl="0" fontAlgn="b"/>
                      <a:r>
                        <a:rPr lang="de-D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OT</a:t>
                      </a:r>
                    </a:p>
                  </a:txBody>
                  <a:tcPr marL="6429" marR="6429" marT="6429" marB="0" anchor="b"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151953769"/>
                  </a:ext>
                </a:extLst>
              </a:tr>
              <a:tr h="135017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700" u="none" strike="noStrike">
                          <a:effectLst/>
                        </a:rPr>
                        <a:t>X²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429" marR="6429" marT="642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700" u="none" strike="noStrike">
                          <a:effectLst/>
                        </a:rPr>
                        <a:t>df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429" marR="6429" marT="642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700" u="none" strike="noStrike">
                          <a:effectLst/>
                        </a:rPr>
                        <a:t>p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429" marR="6429" marT="642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700" u="none" strike="noStrike">
                          <a:effectLst/>
                        </a:rPr>
                        <a:t>Cramer-V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429" marR="6429" marT="642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700" u="none" strike="noStrike">
                          <a:effectLst/>
                        </a:rPr>
                        <a:t>n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429" marR="6429" marT="642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700" u="none" strike="noStrike">
                          <a:effectLst/>
                        </a:rPr>
                        <a:t>X²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429" marR="6429" marT="642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700" u="none" strike="noStrike">
                          <a:effectLst/>
                        </a:rPr>
                        <a:t>df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429" marR="6429" marT="642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700" u="none" strike="noStrike">
                          <a:effectLst/>
                        </a:rPr>
                        <a:t>p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429" marR="6429" marT="642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700" u="none" strike="noStrike">
                          <a:effectLst/>
                        </a:rPr>
                        <a:t>Cramer-V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429" marR="6429" marT="642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700" u="none" strike="noStrike">
                          <a:effectLst/>
                        </a:rPr>
                        <a:t>n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429" marR="6429" marT="6429" marB="0" anchor="b"/>
                </a:tc>
                <a:extLst>
                  <a:ext uri="{0D108BD9-81ED-4DB2-BD59-A6C34878D82A}">
                    <a16:rowId xmlns:a16="http://schemas.microsoft.com/office/drawing/2014/main" val="892668988"/>
                  </a:ext>
                </a:extLst>
              </a:tr>
              <a:tr h="135017">
                <a:tc>
                  <a:txBody>
                    <a:bodyPr/>
                    <a:lstStyle/>
                    <a:p>
                      <a:pPr algn="l" rtl="0" fontAlgn="b"/>
                      <a:r>
                        <a:rPr lang="de-DE" sz="700" u="none" strike="noStrike">
                          <a:effectLst/>
                        </a:rPr>
                        <a:t>Nicotine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429" marR="6429" marT="642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,105</a:t>
                      </a:r>
                    </a:p>
                  </a:txBody>
                  <a:tcPr marL="6429" marR="6429" marT="642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6429" marR="6429" marT="642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700" u="none" strike="noStrike" dirty="0">
                          <a:effectLst/>
                        </a:rPr>
                        <a:t>0,949</a:t>
                      </a:r>
                      <a:endParaRPr lang="de-DE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429" marR="6429" marT="642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700" u="none" strike="noStrike" dirty="0">
                          <a:effectLst/>
                        </a:rPr>
                        <a:t>0,032</a:t>
                      </a:r>
                      <a:endParaRPr lang="de-DE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429" marR="6429" marT="642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700" u="none" strike="noStrike" dirty="0">
                          <a:effectLst/>
                        </a:rPr>
                        <a:t>103</a:t>
                      </a:r>
                      <a:endParaRPr lang="de-DE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429" marR="6429" marT="642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700" u="none" strike="noStrike" dirty="0">
                          <a:effectLst/>
                        </a:rPr>
                        <a:t>2,865</a:t>
                      </a:r>
                      <a:endParaRPr lang="de-DE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429" marR="6429" marT="642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6429" marR="6429" marT="642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700" u="none" strike="noStrike" dirty="0">
                          <a:effectLst/>
                        </a:rPr>
                        <a:t>0,239*</a:t>
                      </a:r>
                      <a:endParaRPr lang="de-DE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429" marR="6429" marT="642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700" u="none" strike="noStrike" dirty="0">
                          <a:effectLst/>
                        </a:rPr>
                        <a:t>0,353</a:t>
                      </a:r>
                      <a:endParaRPr lang="de-DE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429" marR="6429" marT="642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700" u="none" strike="noStrike" dirty="0">
                          <a:effectLst/>
                        </a:rPr>
                        <a:t>23</a:t>
                      </a:r>
                      <a:endParaRPr lang="de-DE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429" marR="6429" marT="6429" marB="0" anchor="b"/>
                </a:tc>
                <a:extLst>
                  <a:ext uri="{0D108BD9-81ED-4DB2-BD59-A6C34878D82A}">
                    <a16:rowId xmlns:a16="http://schemas.microsoft.com/office/drawing/2014/main" val="3810621244"/>
                  </a:ext>
                </a:extLst>
              </a:tr>
              <a:tr h="135017">
                <a:tc>
                  <a:txBody>
                    <a:bodyPr/>
                    <a:lstStyle/>
                    <a:p>
                      <a:pPr algn="l" rtl="0" fontAlgn="b"/>
                      <a:r>
                        <a:rPr lang="de-DE" sz="700" u="none" strike="noStrike">
                          <a:effectLst/>
                        </a:rPr>
                        <a:t>Systemic therapy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429" marR="6429" marT="642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700" b="1" u="none" strike="noStrike" dirty="0">
                          <a:effectLst/>
                        </a:rPr>
                        <a:t>6,653</a:t>
                      </a:r>
                      <a:endParaRPr lang="de-DE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429" marR="6429" marT="6429" marB="0" anchor="b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700" b="1" u="none" strike="noStrike" dirty="0">
                          <a:effectLst/>
                        </a:rPr>
                        <a:t>1</a:t>
                      </a:r>
                      <a:endParaRPr lang="de-DE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429" marR="6429" marT="6429" marB="0" anchor="b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700" b="1" u="none" strike="noStrike" dirty="0">
                          <a:effectLst/>
                        </a:rPr>
                        <a:t>0,01</a:t>
                      </a:r>
                      <a:endParaRPr lang="de-DE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429" marR="6429" marT="6429" marB="0" anchor="b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700" b="1" u="none" strike="noStrike" dirty="0">
                          <a:effectLst/>
                        </a:rPr>
                        <a:t>0,208</a:t>
                      </a:r>
                      <a:endParaRPr lang="de-DE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429" marR="6429" marT="6429" marB="0" anchor="b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700" b="1" u="none" strike="noStrike" dirty="0">
                          <a:effectLst/>
                        </a:rPr>
                        <a:t>154</a:t>
                      </a:r>
                      <a:endParaRPr lang="de-DE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429" marR="6429" marT="6429" marB="0" anchor="b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700" u="none" strike="noStrike">
                          <a:effectLst/>
                        </a:rPr>
                        <a:t>0,793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429" marR="6429" marT="642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700" u="none" strike="noStrike">
                          <a:effectLst/>
                        </a:rPr>
                        <a:t>1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429" marR="6429" marT="642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700" u="none" strike="noStrike">
                          <a:effectLst/>
                        </a:rPr>
                        <a:t>0,373*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429" marR="6429" marT="642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700" u="none" strike="noStrike">
                          <a:effectLst/>
                        </a:rPr>
                        <a:t>0,171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429" marR="6429" marT="642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700" u="none" strike="noStrike">
                          <a:effectLst/>
                        </a:rPr>
                        <a:t>27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429" marR="6429" marT="6429" marB="0" anchor="b"/>
                </a:tc>
                <a:extLst>
                  <a:ext uri="{0D108BD9-81ED-4DB2-BD59-A6C34878D82A}">
                    <a16:rowId xmlns:a16="http://schemas.microsoft.com/office/drawing/2014/main" val="1686490519"/>
                  </a:ext>
                </a:extLst>
              </a:tr>
              <a:tr h="135017">
                <a:tc>
                  <a:txBody>
                    <a:bodyPr/>
                    <a:lstStyle/>
                    <a:p>
                      <a:pPr algn="l" rtl="0" fontAlgn="b"/>
                      <a:r>
                        <a:rPr lang="de-DE" sz="700" u="none" strike="noStrike">
                          <a:effectLst/>
                        </a:rPr>
                        <a:t>Chemotherapy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429" marR="6429" marT="642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700" b="1" u="none" strike="noStrike" dirty="0">
                          <a:effectLst/>
                        </a:rPr>
                        <a:t>10,893</a:t>
                      </a:r>
                      <a:endParaRPr lang="de-DE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429" marR="6429" marT="6429" marB="0" anchor="b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6429" marR="6429" marT="6429" marB="0" anchor="b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700" b="1" u="none" strike="noStrike" dirty="0">
                          <a:effectLst/>
                        </a:rPr>
                        <a:t>0,012*</a:t>
                      </a:r>
                      <a:endParaRPr lang="de-DE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429" marR="6429" marT="6429" marB="0" anchor="b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700" b="1" u="none" strike="noStrike" dirty="0">
                          <a:effectLst/>
                        </a:rPr>
                        <a:t>0,266</a:t>
                      </a:r>
                      <a:endParaRPr lang="de-DE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429" marR="6429" marT="6429" marB="0" anchor="b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700" b="1" u="none" strike="noStrike" dirty="0">
                          <a:effectLst/>
                        </a:rPr>
                        <a:t>154</a:t>
                      </a:r>
                      <a:endParaRPr lang="de-DE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429" marR="6429" marT="6429" marB="0" anchor="b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700" u="none" strike="noStrike">
                          <a:effectLst/>
                        </a:rPr>
                        <a:t>1,109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429" marR="6429" marT="642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700" u="none" strike="noStrike">
                          <a:effectLst/>
                        </a:rPr>
                        <a:t>2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429" marR="6429" marT="642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700" u="none" strike="noStrike">
                          <a:effectLst/>
                        </a:rPr>
                        <a:t>0,574*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429" marR="6429" marT="642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700" u="none" strike="noStrike">
                          <a:effectLst/>
                        </a:rPr>
                        <a:t>0,203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429" marR="6429" marT="642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700" u="none" strike="noStrike">
                          <a:effectLst/>
                        </a:rPr>
                        <a:t>27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429" marR="6429" marT="6429" marB="0" anchor="b"/>
                </a:tc>
                <a:extLst>
                  <a:ext uri="{0D108BD9-81ED-4DB2-BD59-A6C34878D82A}">
                    <a16:rowId xmlns:a16="http://schemas.microsoft.com/office/drawing/2014/main" val="1497564910"/>
                  </a:ext>
                </a:extLst>
              </a:tr>
              <a:tr h="135017">
                <a:tc>
                  <a:txBody>
                    <a:bodyPr/>
                    <a:lstStyle/>
                    <a:p>
                      <a:pPr algn="l" rtl="0" fontAlgn="b"/>
                      <a:r>
                        <a:rPr lang="de-DE" sz="700" u="none" strike="noStrike">
                          <a:effectLst/>
                        </a:rPr>
                        <a:t>Immunotherapy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429" marR="6429" marT="642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700" b="1" u="none" strike="noStrike" dirty="0">
                          <a:effectLst/>
                        </a:rPr>
                        <a:t>11,579</a:t>
                      </a:r>
                      <a:endParaRPr lang="de-DE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429" marR="6429" marT="6429" marB="0" anchor="b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6429" marR="6429" marT="6429" marB="0" anchor="b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700" b="1" u="none" strike="noStrike" dirty="0">
                          <a:effectLst/>
                        </a:rPr>
                        <a:t>0,009*</a:t>
                      </a:r>
                      <a:endParaRPr lang="de-DE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429" marR="6429" marT="6429" marB="0" anchor="b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700" b="1" u="none" strike="noStrike" dirty="0">
                          <a:effectLst/>
                        </a:rPr>
                        <a:t>0,274</a:t>
                      </a:r>
                      <a:endParaRPr lang="de-DE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429" marR="6429" marT="6429" marB="0" anchor="b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700" b="1" u="none" strike="noStrike" dirty="0">
                          <a:effectLst/>
                        </a:rPr>
                        <a:t>154</a:t>
                      </a:r>
                      <a:endParaRPr lang="de-DE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429" marR="6429" marT="6429" marB="0" anchor="b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700" u="none" strike="noStrike">
                          <a:effectLst/>
                        </a:rPr>
                        <a:t>NA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429" marR="6429" marT="642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700" u="none" strike="noStrike">
                          <a:effectLst/>
                        </a:rPr>
                        <a:t> 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429" marR="6429" marT="642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700" u="none" strike="noStrike">
                          <a:effectLst/>
                        </a:rPr>
                        <a:t> 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429" marR="6429" marT="642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700" u="none" strike="noStrike">
                          <a:effectLst/>
                        </a:rPr>
                        <a:t> 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429" marR="6429" marT="642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700" u="none" strike="noStrike">
                          <a:effectLst/>
                        </a:rPr>
                        <a:t> 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429" marR="6429" marT="6429" marB="0" anchor="b"/>
                </a:tc>
                <a:extLst>
                  <a:ext uri="{0D108BD9-81ED-4DB2-BD59-A6C34878D82A}">
                    <a16:rowId xmlns:a16="http://schemas.microsoft.com/office/drawing/2014/main" val="996106299"/>
                  </a:ext>
                </a:extLst>
              </a:tr>
              <a:tr h="135017">
                <a:tc>
                  <a:txBody>
                    <a:bodyPr/>
                    <a:lstStyle/>
                    <a:p>
                      <a:pPr algn="l" rtl="0" fontAlgn="b"/>
                      <a:r>
                        <a:rPr lang="de-DE" sz="700" u="none" strike="noStrike">
                          <a:effectLst/>
                        </a:rPr>
                        <a:t>Alcohol abusus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429" marR="6429" marT="642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700" u="none" strike="noStrike" dirty="0">
                          <a:effectLst/>
                        </a:rPr>
                        <a:t>0,008</a:t>
                      </a:r>
                      <a:endParaRPr lang="de-DE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429" marR="6429" marT="642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6429" marR="6429" marT="642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700" u="none" strike="noStrike" dirty="0">
                          <a:effectLst/>
                        </a:rPr>
                        <a:t>0,996*</a:t>
                      </a:r>
                      <a:endParaRPr lang="de-DE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429" marR="6429" marT="642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700" u="none" strike="noStrike" dirty="0">
                          <a:effectLst/>
                        </a:rPr>
                        <a:t>0,009</a:t>
                      </a:r>
                      <a:endParaRPr lang="de-DE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429" marR="6429" marT="642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700" u="none" strike="noStrike" dirty="0">
                          <a:effectLst/>
                        </a:rPr>
                        <a:t>104</a:t>
                      </a:r>
                      <a:endParaRPr lang="de-DE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429" marR="6429" marT="642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700" b="1" u="none" strike="noStrike" dirty="0">
                          <a:effectLst/>
                        </a:rPr>
                        <a:t>6,356</a:t>
                      </a:r>
                      <a:endParaRPr lang="de-DE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429" marR="6429" marT="6429" marB="0" anchor="b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6429" marR="6429" marT="6429" marB="0" anchor="b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700" b="1" u="none" strike="noStrike" dirty="0">
                          <a:effectLst/>
                        </a:rPr>
                        <a:t>0,042*</a:t>
                      </a:r>
                      <a:endParaRPr lang="de-DE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429" marR="6429" marT="6429" marB="0" anchor="b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700" b="1" u="none" strike="noStrike" dirty="0">
                          <a:effectLst/>
                        </a:rPr>
                        <a:t>0,515</a:t>
                      </a:r>
                      <a:endParaRPr lang="de-DE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429" marR="6429" marT="6429" marB="0" anchor="b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700" b="1" u="none" strike="noStrike" dirty="0">
                          <a:effectLst/>
                        </a:rPr>
                        <a:t>27</a:t>
                      </a:r>
                      <a:endParaRPr lang="de-DE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429" marR="6429" marT="6429" marB="0" anchor="b"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72542136"/>
                  </a:ext>
                </a:extLst>
              </a:tr>
              <a:tr h="135017">
                <a:tc>
                  <a:txBody>
                    <a:bodyPr/>
                    <a:lstStyle/>
                    <a:p>
                      <a:pPr algn="l" rtl="0" fontAlgn="b"/>
                      <a:r>
                        <a:rPr lang="de-DE" sz="700" u="none" strike="noStrike">
                          <a:effectLst/>
                        </a:rPr>
                        <a:t>Entity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429" marR="6429" marT="642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700" u="none" strike="noStrike">
                          <a:effectLst/>
                        </a:rPr>
                        <a:t>9,319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429" marR="6429" marT="642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700" u="none" strike="noStrike">
                          <a:effectLst/>
                        </a:rPr>
                        <a:t>8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429" marR="6429" marT="642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700" u="none" strike="noStrike">
                          <a:effectLst/>
                        </a:rPr>
                        <a:t>0,316*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429" marR="6429" marT="642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700" u="none" strike="noStrike">
                          <a:effectLst/>
                        </a:rPr>
                        <a:t>0,244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429" marR="6429" marT="642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700" u="none" strike="noStrike">
                          <a:effectLst/>
                        </a:rPr>
                        <a:t>156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429" marR="6429" marT="642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700" u="none" strike="noStrike">
                          <a:effectLst/>
                        </a:rPr>
                        <a:t>3,26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429" marR="6429" marT="642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700" u="none" strike="noStrike" dirty="0">
                          <a:effectLst/>
                        </a:rPr>
                        <a:t>5</a:t>
                      </a:r>
                      <a:endParaRPr lang="de-DE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429" marR="6429" marT="642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700" u="none" strike="noStrike">
                          <a:effectLst/>
                        </a:rPr>
                        <a:t>0,660*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429" marR="6429" marT="642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700" u="none" strike="noStrike">
                          <a:effectLst/>
                        </a:rPr>
                        <a:t>0,347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429" marR="6429" marT="642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700" u="none" strike="noStrike">
                          <a:effectLst/>
                        </a:rPr>
                        <a:t>27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429" marR="6429" marT="6429" marB="0" anchor="b"/>
                </a:tc>
                <a:extLst>
                  <a:ext uri="{0D108BD9-81ED-4DB2-BD59-A6C34878D82A}">
                    <a16:rowId xmlns:a16="http://schemas.microsoft.com/office/drawing/2014/main" val="1123044540"/>
                  </a:ext>
                </a:extLst>
              </a:tr>
              <a:tr h="231457">
                <a:tc>
                  <a:txBody>
                    <a:bodyPr/>
                    <a:lstStyle/>
                    <a:p>
                      <a:pPr algn="l" rtl="0" fontAlgn="b"/>
                      <a:r>
                        <a:rPr lang="de-DE" sz="700" u="none" strike="noStrike">
                          <a:effectLst/>
                        </a:rPr>
                        <a:t>Curative treatment intent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429" marR="6429" marT="642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700" u="none" strike="noStrike">
                          <a:effectLst/>
                        </a:rPr>
                        <a:t>1,214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429" marR="6429" marT="642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700" u="none" strike="noStrike">
                          <a:effectLst/>
                        </a:rPr>
                        <a:t>1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429" marR="6429" marT="642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700" u="none" strike="noStrike">
                          <a:effectLst/>
                        </a:rPr>
                        <a:t>0,271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429" marR="6429" marT="642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700" u="none" strike="noStrike">
                          <a:effectLst/>
                        </a:rPr>
                        <a:t>0,088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429" marR="6429" marT="642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700" u="none" strike="noStrike">
                          <a:effectLst/>
                        </a:rPr>
                        <a:t>156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429" marR="6429" marT="642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700" u="none" strike="noStrike">
                          <a:effectLst/>
                        </a:rPr>
                        <a:t>3,431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429" marR="6429" marT="642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700" u="none" strike="noStrike">
                          <a:effectLst/>
                        </a:rPr>
                        <a:t>1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429" marR="6429" marT="642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700" u="none" strike="noStrike">
                          <a:effectLst/>
                        </a:rPr>
                        <a:t>0,064*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429" marR="6429" marT="642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700" u="none" strike="noStrike">
                          <a:effectLst/>
                        </a:rPr>
                        <a:t>0,356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429" marR="6429" marT="642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700" u="none" strike="noStrike">
                          <a:effectLst/>
                        </a:rPr>
                        <a:t>27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429" marR="6429" marT="6429" marB="0" anchor="b"/>
                </a:tc>
                <a:extLst>
                  <a:ext uri="{0D108BD9-81ED-4DB2-BD59-A6C34878D82A}">
                    <a16:rowId xmlns:a16="http://schemas.microsoft.com/office/drawing/2014/main" val="3199512798"/>
                  </a:ext>
                </a:extLst>
              </a:tr>
              <a:tr h="135017">
                <a:tc>
                  <a:txBody>
                    <a:bodyPr/>
                    <a:lstStyle/>
                    <a:p>
                      <a:pPr algn="l" rtl="0" fontAlgn="b"/>
                      <a:r>
                        <a:rPr lang="de-DE" sz="700" u="none" strike="noStrike">
                          <a:effectLst/>
                        </a:rPr>
                        <a:t>Gender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429" marR="6429" marT="642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700" u="none" strike="noStrike">
                          <a:effectLst/>
                        </a:rPr>
                        <a:t>0,032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429" marR="6429" marT="642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700" u="none" strike="noStrike">
                          <a:effectLst/>
                        </a:rPr>
                        <a:t>1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429" marR="6429" marT="642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700" u="none" strike="noStrike">
                          <a:effectLst/>
                        </a:rPr>
                        <a:t>0,858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429" marR="6429" marT="642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700" u="none" strike="noStrike">
                          <a:effectLst/>
                        </a:rPr>
                        <a:t>0,012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429" marR="6429" marT="642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700" u="none" strike="noStrike">
                          <a:effectLst/>
                        </a:rPr>
                        <a:t>156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429" marR="6429" marT="642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700" u="none" strike="noStrike">
                          <a:effectLst/>
                        </a:rPr>
                        <a:t>2,584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429" marR="6429" marT="642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700" u="none" strike="noStrike">
                          <a:effectLst/>
                        </a:rPr>
                        <a:t>1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429" marR="6429" marT="642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700" u="none" strike="noStrike">
                          <a:effectLst/>
                        </a:rPr>
                        <a:t>0,108*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429" marR="6429" marT="642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700" u="none" strike="noStrike">
                          <a:effectLst/>
                        </a:rPr>
                        <a:t>0,309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429" marR="6429" marT="6429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700" u="none" strike="noStrike" dirty="0">
                          <a:effectLst/>
                        </a:rPr>
                        <a:t>27</a:t>
                      </a:r>
                      <a:endParaRPr lang="de-DE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429" marR="6429" marT="6429" marB="0" anchor="b"/>
                </a:tc>
                <a:extLst>
                  <a:ext uri="{0D108BD9-81ED-4DB2-BD59-A6C34878D82A}">
                    <a16:rowId xmlns:a16="http://schemas.microsoft.com/office/drawing/2014/main" val="172281699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68681851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>
            <a:extLst>
              <a:ext uri="{FF2B5EF4-FFF2-40B4-BE49-F238E27FC236}">
                <a16:creationId xmlns:a16="http://schemas.microsoft.com/office/drawing/2014/main" id="{C5542A98-B127-8A9A-EE89-300E5BE72B18}"/>
              </a:ext>
            </a:extLst>
          </p:cNvPr>
          <p:cNvSpPr txBox="1"/>
          <p:nvPr/>
        </p:nvSpPr>
        <p:spPr>
          <a:xfrm>
            <a:off x="365350" y="8818402"/>
            <a:ext cx="637200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err="1"/>
              <a:t>Suppl</a:t>
            </a:r>
            <a:r>
              <a:rPr lang="de-DE" sz="1200" dirty="0"/>
              <a:t>. </a:t>
            </a:r>
            <a:r>
              <a:rPr lang="de-DE" sz="1200" dirty="0" err="1"/>
              <a:t>Tabl</a:t>
            </a:r>
            <a:r>
              <a:rPr lang="de-DE" sz="1200" dirty="0"/>
              <a:t>. 3: </a:t>
            </a:r>
            <a:r>
              <a:rPr lang="de-DE" sz="1200" dirty="0" err="1"/>
              <a:t>Overview</a:t>
            </a:r>
            <a:r>
              <a:rPr lang="de-DE" sz="1200" dirty="0"/>
              <a:t> </a:t>
            </a:r>
            <a:r>
              <a:rPr lang="de-DE" sz="1200" dirty="0" err="1"/>
              <a:t>over</a:t>
            </a:r>
            <a:r>
              <a:rPr lang="de-DE" sz="1200" dirty="0"/>
              <a:t> </a:t>
            </a:r>
            <a:r>
              <a:rPr lang="de-DE" sz="1200" dirty="0" err="1"/>
              <a:t>results</a:t>
            </a:r>
            <a:r>
              <a:rPr lang="de-DE" sz="1200" dirty="0"/>
              <a:t> </a:t>
            </a:r>
            <a:r>
              <a:rPr lang="de-DE" sz="1200" dirty="0" err="1"/>
              <a:t>of</a:t>
            </a:r>
            <a:r>
              <a:rPr lang="de-DE" sz="1200" dirty="0"/>
              <a:t> bivariate </a:t>
            </a:r>
            <a:r>
              <a:rPr lang="de-DE" sz="1200" dirty="0" err="1"/>
              <a:t>analysis</a:t>
            </a:r>
            <a:r>
              <a:rPr lang="de-DE" sz="1200" dirty="0"/>
              <a:t> </a:t>
            </a:r>
            <a:r>
              <a:rPr lang="en-US" sz="1200" dirty="0"/>
              <a:t>for data of patients with TSAT below 20% . Significant values are marked by bold lettering and yellow </a:t>
            </a:r>
            <a:r>
              <a:rPr lang="en-US" sz="1200" dirty="0" err="1"/>
              <a:t>colour</a:t>
            </a:r>
            <a:r>
              <a:rPr lang="en-US" sz="1200" dirty="0"/>
              <a:t>. CRP= C-reactive Protein, BMI= body mass index, GTV=gross target volume, HB= hemoglobin, </a:t>
            </a:r>
            <a:r>
              <a:rPr lang="en-US" sz="1200" dirty="0" err="1"/>
              <a:t>Hct</a:t>
            </a:r>
            <a:r>
              <a:rPr lang="en-US" sz="1200" dirty="0"/>
              <a:t>= hematocrit, KI= </a:t>
            </a:r>
            <a:r>
              <a:rPr lang="en-US" sz="1200" dirty="0" err="1"/>
              <a:t>Karnofsky</a:t>
            </a:r>
            <a:r>
              <a:rPr lang="en-US" sz="1200" dirty="0"/>
              <a:t> Index, N= number of patients, NLR= neutrophil-to-lymphocyte ratio, PLR=platelet-to-lymphocyte ratio, PTV= planned target volume, RT= radiotherapy, RTE= end of radiotherapy.</a:t>
            </a:r>
            <a:endParaRPr lang="de-DE" sz="1200" dirty="0"/>
          </a:p>
        </p:txBody>
      </p:sp>
      <p:sp>
        <p:nvSpPr>
          <p:cNvPr id="5" name="Textfeld 4">
            <a:extLst>
              <a:ext uri="{FF2B5EF4-FFF2-40B4-BE49-F238E27FC236}">
                <a16:creationId xmlns:a16="http://schemas.microsoft.com/office/drawing/2014/main" id="{EBDA8322-8BB8-32B7-9DFC-4AAFFFA99C85}"/>
              </a:ext>
            </a:extLst>
          </p:cNvPr>
          <p:cNvSpPr txBox="1"/>
          <p:nvPr/>
        </p:nvSpPr>
        <p:spPr>
          <a:xfrm>
            <a:off x="245823" y="830328"/>
            <a:ext cx="4776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b="1" dirty="0"/>
              <a:t>A</a:t>
            </a:r>
          </a:p>
        </p:txBody>
      </p:sp>
      <p:sp>
        <p:nvSpPr>
          <p:cNvPr id="6" name="Textfeld 5">
            <a:extLst>
              <a:ext uri="{FF2B5EF4-FFF2-40B4-BE49-F238E27FC236}">
                <a16:creationId xmlns:a16="http://schemas.microsoft.com/office/drawing/2014/main" id="{C1953E60-9F8A-F6AA-FCD1-2B143273BD53}"/>
              </a:ext>
            </a:extLst>
          </p:cNvPr>
          <p:cNvSpPr txBox="1"/>
          <p:nvPr/>
        </p:nvSpPr>
        <p:spPr>
          <a:xfrm>
            <a:off x="245823" y="5027018"/>
            <a:ext cx="4776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b="1" dirty="0"/>
              <a:t>B</a:t>
            </a:r>
          </a:p>
        </p:txBody>
      </p:sp>
      <p:pic>
        <p:nvPicPr>
          <p:cNvPr id="10" name="Grafik 9">
            <a:extLst>
              <a:ext uri="{FF2B5EF4-FFF2-40B4-BE49-F238E27FC236}">
                <a16:creationId xmlns:a16="http://schemas.microsoft.com/office/drawing/2014/main" id="{45A634E4-7153-4780-83CE-A8F29C7E0A8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87627" y="883449"/>
            <a:ext cx="5924550" cy="3648075"/>
          </a:xfrm>
          <a:prstGeom prst="rect">
            <a:avLst/>
          </a:prstGeom>
        </p:spPr>
      </p:pic>
      <p:pic>
        <p:nvPicPr>
          <p:cNvPr id="11" name="Grafik 10">
            <a:extLst>
              <a:ext uri="{FF2B5EF4-FFF2-40B4-BE49-F238E27FC236}">
                <a16:creationId xmlns:a16="http://schemas.microsoft.com/office/drawing/2014/main" id="{EC4E15EA-CE43-48CB-BE9F-65EAB1E9968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59052" y="4878982"/>
            <a:ext cx="5981700" cy="38481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3313155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elle 1">
            <a:extLst>
              <a:ext uri="{FF2B5EF4-FFF2-40B4-BE49-F238E27FC236}">
                <a16:creationId xmlns:a16="http://schemas.microsoft.com/office/drawing/2014/main" id="{39CD1307-F843-4237-9762-E8F52D75940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50811829"/>
              </p:ext>
            </p:extLst>
          </p:nvPr>
        </p:nvGraphicFramePr>
        <p:xfrm>
          <a:off x="431801" y="912709"/>
          <a:ext cx="5612888" cy="8543118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1681173">
                  <a:extLst>
                    <a:ext uri="{9D8B030D-6E8A-4147-A177-3AD203B41FA5}">
                      <a16:colId xmlns:a16="http://schemas.microsoft.com/office/drawing/2014/main" val="3177376901"/>
                    </a:ext>
                  </a:extLst>
                </a:gridCol>
                <a:gridCol w="970395">
                  <a:extLst>
                    <a:ext uri="{9D8B030D-6E8A-4147-A177-3AD203B41FA5}">
                      <a16:colId xmlns:a16="http://schemas.microsoft.com/office/drawing/2014/main" val="3297551873"/>
                    </a:ext>
                  </a:extLst>
                </a:gridCol>
                <a:gridCol w="740330">
                  <a:extLst>
                    <a:ext uri="{9D8B030D-6E8A-4147-A177-3AD203B41FA5}">
                      <a16:colId xmlns:a16="http://schemas.microsoft.com/office/drawing/2014/main" val="1593870066"/>
                    </a:ext>
                  </a:extLst>
                </a:gridCol>
                <a:gridCol w="740330">
                  <a:extLst>
                    <a:ext uri="{9D8B030D-6E8A-4147-A177-3AD203B41FA5}">
                      <a16:colId xmlns:a16="http://schemas.microsoft.com/office/drawing/2014/main" val="50558953"/>
                    </a:ext>
                  </a:extLst>
                </a:gridCol>
                <a:gridCol w="740330">
                  <a:extLst>
                    <a:ext uri="{9D8B030D-6E8A-4147-A177-3AD203B41FA5}">
                      <a16:colId xmlns:a16="http://schemas.microsoft.com/office/drawing/2014/main" val="1933953703"/>
                    </a:ext>
                  </a:extLst>
                </a:gridCol>
                <a:gridCol w="740330">
                  <a:extLst>
                    <a:ext uri="{9D8B030D-6E8A-4147-A177-3AD203B41FA5}">
                      <a16:colId xmlns:a16="http://schemas.microsoft.com/office/drawing/2014/main" val="2609194811"/>
                    </a:ext>
                  </a:extLst>
                </a:gridCol>
              </a:tblGrid>
              <a:tr h="152399"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 </a:t>
                      </a: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 gridSpan="2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de-DE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TSAT</a:t>
                      </a:r>
                    </a:p>
                  </a:txBody>
                  <a:tcPr marL="49606" marR="49606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de-DE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extLst>
                  <a:ext uri="{0D108BD9-81ED-4DB2-BD59-A6C34878D82A}">
                    <a16:rowId xmlns:a16="http://schemas.microsoft.com/office/drawing/2014/main" val="3365503591"/>
                  </a:ext>
                </a:extLst>
              </a:tr>
              <a:tr h="152399"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</a:rPr>
                        <a:t>Gender n (%)</a:t>
                      </a: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</a:rPr>
                        <a:t> </a:t>
                      </a: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</a:rPr>
                        <a:t> all </a:t>
                      </a:r>
                      <a:r>
                        <a:rPr lang="de-DE" sz="800" dirty="0" err="1">
                          <a:effectLst/>
                        </a:rPr>
                        <a:t>patients</a:t>
                      </a:r>
                      <a:r>
                        <a:rPr lang="de-DE" sz="800" dirty="0">
                          <a:effectLst/>
                        </a:rPr>
                        <a:t> (n=26)</a:t>
                      </a:r>
                      <a:endParaRPr lang="de-DE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Increase</a:t>
                      </a: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(n=17)</a:t>
                      </a: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o</a:t>
                      </a: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800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hange</a:t>
                      </a: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(n=4)</a:t>
                      </a: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Decrease</a:t>
                      </a: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(n=5)</a:t>
                      </a:r>
                    </a:p>
                  </a:txBody>
                  <a:tcPr marL="49606" marR="49606" marT="0" marB="0"/>
                </a:tc>
                <a:extLst>
                  <a:ext uri="{0D108BD9-81ED-4DB2-BD59-A6C34878D82A}">
                    <a16:rowId xmlns:a16="http://schemas.microsoft.com/office/drawing/2014/main" val="2205265679"/>
                  </a:ext>
                </a:extLst>
              </a:tr>
              <a:tr h="152399"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</a:rPr>
                        <a:t> </a:t>
                      </a: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</a:rPr>
                        <a:t>Female</a:t>
                      </a: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6 (23.1)</a:t>
                      </a: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2 (70.6)</a:t>
                      </a: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 (100)</a:t>
                      </a: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 (80)</a:t>
                      </a:r>
                    </a:p>
                  </a:txBody>
                  <a:tcPr marL="49606" marR="49606" marT="0" marB="0"/>
                </a:tc>
                <a:extLst>
                  <a:ext uri="{0D108BD9-81ED-4DB2-BD59-A6C34878D82A}">
                    <a16:rowId xmlns:a16="http://schemas.microsoft.com/office/drawing/2014/main" val="2049651222"/>
                  </a:ext>
                </a:extLst>
              </a:tr>
              <a:tr h="152399"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</a:rPr>
                        <a:t> </a:t>
                      </a: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</a:rPr>
                        <a:t>Male</a:t>
                      </a: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0 (76.9)</a:t>
                      </a: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 (29.4)</a:t>
                      </a: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 (0)</a:t>
                      </a: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 (20)</a:t>
                      </a:r>
                    </a:p>
                  </a:txBody>
                  <a:tcPr marL="49606" marR="49606" marT="0" marB="0"/>
                </a:tc>
                <a:extLst>
                  <a:ext uri="{0D108BD9-81ED-4DB2-BD59-A6C34878D82A}">
                    <a16:rowId xmlns:a16="http://schemas.microsoft.com/office/drawing/2014/main" val="146515264"/>
                  </a:ext>
                </a:extLst>
              </a:tr>
              <a:tr h="152399"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</a:rPr>
                        <a:t>Age [years](mean, range)</a:t>
                      </a: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</a:rPr>
                        <a:t> </a:t>
                      </a: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60.9 (45-76)</a:t>
                      </a: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60.2 (45-76)</a:t>
                      </a: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60.3 (53-66)</a:t>
                      </a: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63.8 (55-68)</a:t>
                      </a:r>
                    </a:p>
                  </a:txBody>
                  <a:tcPr marL="49606" marR="49606" marT="0" marB="0"/>
                </a:tc>
                <a:extLst>
                  <a:ext uri="{0D108BD9-81ED-4DB2-BD59-A6C34878D82A}">
                    <a16:rowId xmlns:a16="http://schemas.microsoft.com/office/drawing/2014/main" val="2366933615"/>
                  </a:ext>
                </a:extLst>
              </a:tr>
              <a:tr h="152399"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</a:rPr>
                        <a:t>Height [cm] (mean, range)</a:t>
                      </a: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</a:rPr>
                        <a:t>n=23</a:t>
                      </a:r>
                      <a:endParaRPr lang="de-DE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77.3 (159-200)</a:t>
                      </a: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76.4 (159-197)</a:t>
                      </a: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80 (177-183)</a:t>
                      </a: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79 (165-200)</a:t>
                      </a:r>
                    </a:p>
                  </a:txBody>
                  <a:tcPr marL="49606" marR="49606" marT="0" marB="0"/>
                </a:tc>
                <a:extLst>
                  <a:ext uri="{0D108BD9-81ED-4DB2-BD59-A6C34878D82A}">
                    <a16:rowId xmlns:a16="http://schemas.microsoft.com/office/drawing/2014/main" val="1951972989"/>
                  </a:ext>
                </a:extLst>
              </a:tr>
              <a:tr h="152399"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</a:rPr>
                        <a:t>Weight [kg] (mean, range)</a:t>
                      </a: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</a:rPr>
                        <a:t>n=23</a:t>
                      </a:r>
                      <a:endParaRPr lang="de-DE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79.8 (56-140)</a:t>
                      </a: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81.3 (56-140)</a:t>
                      </a: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82.5 (82-83)</a:t>
                      </a: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74.2 (56-94)</a:t>
                      </a:r>
                    </a:p>
                  </a:txBody>
                  <a:tcPr marL="49606" marR="49606" marT="0" marB="0"/>
                </a:tc>
                <a:extLst>
                  <a:ext uri="{0D108BD9-81ED-4DB2-BD59-A6C34878D82A}">
                    <a16:rowId xmlns:a16="http://schemas.microsoft.com/office/drawing/2014/main" val="2950286478"/>
                  </a:ext>
                </a:extLst>
              </a:tr>
              <a:tr h="152399"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BMI [kg/m²] (mean, range)</a:t>
                      </a: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</a:rPr>
                        <a:t>n=23</a:t>
                      </a:r>
                      <a:endParaRPr lang="de-DE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5.1 (18.2-37.2)</a:t>
                      </a: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5.7 (18.2-37.2)</a:t>
                      </a: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5.5 (24.5-26.5)</a:t>
                      </a: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3.2 (18.5-30.1)</a:t>
                      </a:r>
                    </a:p>
                  </a:txBody>
                  <a:tcPr marL="49606" marR="49606" marT="0" marB="0"/>
                </a:tc>
                <a:extLst>
                  <a:ext uri="{0D108BD9-81ED-4DB2-BD59-A6C34878D82A}">
                    <a16:rowId xmlns:a16="http://schemas.microsoft.com/office/drawing/2014/main" val="1703340498"/>
                  </a:ext>
                </a:extLst>
              </a:tr>
              <a:tr h="152399"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</a:rPr>
                        <a:t>Weight loss (n, %)</a:t>
                      </a: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</a:rPr>
                        <a:t> </a:t>
                      </a: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de-DE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de-DE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de-DE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de-DE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extLst>
                  <a:ext uri="{0D108BD9-81ED-4DB2-BD59-A6C34878D82A}">
                    <a16:rowId xmlns:a16="http://schemas.microsoft.com/office/drawing/2014/main" val="1206432385"/>
                  </a:ext>
                </a:extLst>
              </a:tr>
              <a:tr h="152399"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</a:rPr>
                        <a:t> </a:t>
                      </a: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</a:rPr>
                        <a:t>No weight loss</a:t>
                      </a: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7 (65.4)</a:t>
                      </a: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2 (70.6)</a:t>
                      </a: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 (25.0)</a:t>
                      </a: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 (80)</a:t>
                      </a:r>
                    </a:p>
                  </a:txBody>
                  <a:tcPr marL="49606" marR="49606" marT="0" marB="0"/>
                </a:tc>
                <a:extLst>
                  <a:ext uri="{0D108BD9-81ED-4DB2-BD59-A6C34878D82A}">
                    <a16:rowId xmlns:a16="http://schemas.microsoft.com/office/drawing/2014/main" val="1003995897"/>
                  </a:ext>
                </a:extLst>
              </a:tr>
              <a:tr h="152399"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</a:rPr>
                        <a:t> </a:t>
                      </a: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</a:rPr>
                        <a:t>Weight loss</a:t>
                      </a: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7 (26.9)</a:t>
                      </a: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 (23.5)</a:t>
                      </a: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 (50.0)</a:t>
                      </a: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 (20)</a:t>
                      </a:r>
                    </a:p>
                  </a:txBody>
                  <a:tcPr marL="49606" marR="49606" marT="0" marB="0"/>
                </a:tc>
                <a:extLst>
                  <a:ext uri="{0D108BD9-81ED-4DB2-BD59-A6C34878D82A}">
                    <a16:rowId xmlns:a16="http://schemas.microsoft.com/office/drawing/2014/main" val="446450971"/>
                  </a:ext>
                </a:extLst>
              </a:tr>
              <a:tr h="152399"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</a:rPr>
                        <a:t> </a:t>
                      </a:r>
                      <a:endParaRPr lang="de-DE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</a:rPr>
                        <a:t>NA</a:t>
                      </a:r>
                      <a:endParaRPr lang="de-DE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 (7.7)</a:t>
                      </a: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 (5.9)</a:t>
                      </a: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 (25.0)</a:t>
                      </a: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49606" marR="49606" marT="0" marB="0"/>
                </a:tc>
                <a:extLst>
                  <a:ext uri="{0D108BD9-81ED-4DB2-BD59-A6C34878D82A}">
                    <a16:rowId xmlns:a16="http://schemas.microsoft.com/office/drawing/2014/main" val="1046204747"/>
                  </a:ext>
                </a:extLst>
              </a:tr>
              <a:tr h="152399"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weight loss [kg] (mean, range)</a:t>
                      </a: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 </a:t>
                      </a: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2.3 (2-30)</a:t>
                      </a: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de-DE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de-DE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de-DE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extLst>
                  <a:ext uri="{0D108BD9-81ED-4DB2-BD59-A6C34878D82A}">
                    <a16:rowId xmlns:a16="http://schemas.microsoft.com/office/drawing/2014/main" val="278716453"/>
                  </a:ext>
                </a:extLst>
              </a:tr>
              <a:tr h="152399"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</a:rPr>
                        <a:t>KI [%] (median, range)</a:t>
                      </a: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</a:rPr>
                        <a:t> </a:t>
                      </a: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80 (60-100)</a:t>
                      </a: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80 (60-100)</a:t>
                      </a: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80 (10-100)</a:t>
                      </a: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80 (70-100)</a:t>
                      </a:r>
                    </a:p>
                  </a:txBody>
                  <a:tcPr marL="49606" marR="49606" marT="0" marB="0"/>
                </a:tc>
                <a:extLst>
                  <a:ext uri="{0D108BD9-81ED-4DB2-BD59-A6C34878D82A}">
                    <a16:rowId xmlns:a16="http://schemas.microsoft.com/office/drawing/2014/main" val="1032460817"/>
                  </a:ext>
                </a:extLst>
              </a:tr>
              <a:tr h="152399"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</a:rPr>
                        <a:t> </a:t>
                      </a: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</a:rPr>
                        <a:t>NA</a:t>
                      </a: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49606" marR="49606" marT="0" marB="0"/>
                </a:tc>
                <a:extLst>
                  <a:ext uri="{0D108BD9-81ED-4DB2-BD59-A6C34878D82A}">
                    <a16:rowId xmlns:a16="http://schemas.microsoft.com/office/drawing/2014/main" val="1824427872"/>
                  </a:ext>
                </a:extLst>
              </a:tr>
              <a:tr h="152399"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</a:rPr>
                        <a:t>Tumor Entity (n, %)</a:t>
                      </a: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</a:rPr>
                        <a:t> </a:t>
                      </a: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de-DE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de-DE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de-DE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de-DE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extLst>
                  <a:ext uri="{0D108BD9-81ED-4DB2-BD59-A6C34878D82A}">
                    <a16:rowId xmlns:a16="http://schemas.microsoft.com/office/drawing/2014/main" val="3697368825"/>
                  </a:ext>
                </a:extLst>
              </a:tr>
              <a:tr h="152399"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</a:rPr>
                        <a:t> </a:t>
                      </a: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</a:rPr>
                        <a:t>Lung</a:t>
                      </a: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 (3.8)</a:t>
                      </a: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 (5.9)</a:t>
                      </a: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de-DE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de-DE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extLst>
                  <a:ext uri="{0D108BD9-81ED-4DB2-BD59-A6C34878D82A}">
                    <a16:rowId xmlns:a16="http://schemas.microsoft.com/office/drawing/2014/main" val="3184918226"/>
                  </a:ext>
                </a:extLst>
              </a:tr>
              <a:tr h="152399"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</a:rPr>
                        <a:t> </a:t>
                      </a: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</a:rPr>
                        <a:t>Head &amp; Neck</a:t>
                      </a: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6 (61.5)</a:t>
                      </a: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0 (58.8)</a:t>
                      </a: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 (50)</a:t>
                      </a: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 (80)</a:t>
                      </a:r>
                    </a:p>
                  </a:txBody>
                  <a:tcPr marL="49606" marR="49606" marT="0" marB="0"/>
                </a:tc>
                <a:extLst>
                  <a:ext uri="{0D108BD9-81ED-4DB2-BD59-A6C34878D82A}">
                    <a16:rowId xmlns:a16="http://schemas.microsoft.com/office/drawing/2014/main" val="807169407"/>
                  </a:ext>
                </a:extLst>
              </a:tr>
              <a:tr h="152399"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</a:rPr>
                        <a:t> </a:t>
                      </a: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</a:rPr>
                        <a:t>Rectum/Anal </a:t>
                      </a: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 (3.8)</a:t>
                      </a: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 (5.9)</a:t>
                      </a: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de-DE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de-DE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extLst>
                  <a:ext uri="{0D108BD9-81ED-4DB2-BD59-A6C34878D82A}">
                    <a16:rowId xmlns:a16="http://schemas.microsoft.com/office/drawing/2014/main" val="1739391277"/>
                  </a:ext>
                </a:extLst>
              </a:tr>
              <a:tr h="152399"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</a:rPr>
                        <a:t> </a:t>
                      </a: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</a:rPr>
                        <a:t>Palliative</a:t>
                      </a: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 (15.4)</a:t>
                      </a: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 (11.8)</a:t>
                      </a: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 (25)</a:t>
                      </a: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 (20)</a:t>
                      </a:r>
                    </a:p>
                  </a:txBody>
                  <a:tcPr marL="49606" marR="49606" marT="0" marB="0"/>
                </a:tc>
                <a:extLst>
                  <a:ext uri="{0D108BD9-81ED-4DB2-BD59-A6C34878D82A}">
                    <a16:rowId xmlns:a16="http://schemas.microsoft.com/office/drawing/2014/main" val="1218023987"/>
                  </a:ext>
                </a:extLst>
              </a:tr>
              <a:tr h="152399"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</a:rPr>
                        <a:t> </a:t>
                      </a: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</a:rPr>
                        <a:t>Prostate/Bladder</a:t>
                      </a: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 (7.7)</a:t>
                      </a: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de-DE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de-DE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extLst>
                  <a:ext uri="{0D108BD9-81ED-4DB2-BD59-A6C34878D82A}">
                    <a16:rowId xmlns:a16="http://schemas.microsoft.com/office/drawing/2014/main" val="1925683531"/>
                  </a:ext>
                </a:extLst>
              </a:tr>
              <a:tr h="152399"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</a:rPr>
                        <a:t> </a:t>
                      </a: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</a:rPr>
                        <a:t>Female pelvis</a:t>
                      </a: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 (7.7)</a:t>
                      </a: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 (11.8)</a:t>
                      </a: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de-DE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extLst>
                  <a:ext uri="{0D108BD9-81ED-4DB2-BD59-A6C34878D82A}">
                    <a16:rowId xmlns:a16="http://schemas.microsoft.com/office/drawing/2014/main" val="460140567"/>
                  </a:ext>
                </a:extLst>
              </a:tr>
              <a:tr h="152399"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</a:rPr>
                        <a:t> </a:t>
                      </a: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</a:rPr>
                        <a:t>Brain</a:t>
                      </a: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 (5.9)</a:t>
                      </a: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 (25)</a:t>
                      </a: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extLst>
                  <a:ext uri="{0D108BD9-81ED-4DB2-BD59-A6C34878D82A}">
                    <a16:rowId xmlns:a16="http://schemas.microsoft.com/office/drawing/2014/main" val="255365167"/>
                  </a:ext>
                </a:extLst>
              </a:tr>
              <a:tr h="152399"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</a:rPr>
                        <a:t> </a:t>
                      </a: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</a:rPr>
                        <a:t>Esophagus</a:t>
                      </a: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extLst>
                  <a:ext uri="{0D108BD9-81ED-4DB2-BD59-A6C34878D82A}">
                    <a16:rowId xmlns:a16="http://schemas.microsoft.com/office/drawing/2014/main" val="1867668388"/>
                  </a:ext>
                </a:extLst>
              </a:tr>
              <a:tr h="152399"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</a:rPr>
                        <a:t> </a:t>
                      </a: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</a:rPr>
                        <a:t>other</a:t>
                      </a: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de-DE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extLst>
                  <a:ext uri="{0D108BD9-81ED-4DB2-BD59-A6C34878D82A}">
                    <a16:rowId xmlns:a16="http://schemas.microsoft.com/office/drawing/2014/main" val="2227953038"/>
                  </a:ext>
                </a:extLst>
              </a:tr>
              <a:tr h="152399"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RT total dose [Gy] (mean, range)</a:t>
                      </a: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 </a:t>
                      </a: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60.1 (30-73.8)</a:t>
                      </a: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9.2 (30-73.8)</a:t>
                      </a: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7.5 (30-70.4)</a:t>
                      </a: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65.2 (45-70.4)</a:t>
                      </a:r>
                    </a:p>
                  </a:txBody>
                  <a:tcPr marL="49606" marR="49606" marT="0" marB="0"/>
                </a:tc>
                <a:extLst>
                  <a:ext uri="{0D108BD9-81ED-4DB2-BD59-A6C34878D82A}">
                    <a16:rowId xmlns:a16="http://schemas.microsoft.com/office/drawing/2014/main" val="1754921928"/>
                  </a:ext>
                </a:extLst>
              </a:tr>
              <a:tr h="152399"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RT dose/Fx [Gy] (median, range)</a:t>
                      </a: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 </a:t>
                      </a: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.2 (1.6-6.5)</a:t>
                      </a: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.2 (1.8-6.5)</a:t>
                      </a: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.2 (1.6-3)</a:t>
                      </a: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.2 (2-3)</a:t>
                      </a:r>
                    </a:p>
                  </a:txBody>
                  <a:tcPr marL="49606" marR="49606" marT="0" marB="0"/>
                </a:tc>
                <a:extLst>
                  <a:ext uri="{0D108BD9-81ED-4DB2-BD59-A6C34878D82A}">
                    <a16:rowId xmlns:a16="http://schemas.microsoft.com/office/drawing/2014/main" val="1263649003"/>
                  </a:ext>
                </a:extLst>
              </a:tr>
              <a:tr h="152399"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Number of fractions (median, range)</a:t>
                      </a: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 </a:t>
                      </a: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2 (8-37)</a:t>
                      </a: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1 (8-35)</a:t>
                      </a: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2 (10-37)</a:t>
                      </a: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2 (15-35)</a:t>
                      </a:r>
                    </a:p>
                  </a:txBody>
                  <a:tcPr marL="49606" marR="49606" marT="0" marB="0"/>
                </a:tc>
                <a:extLst>
                  <a:ext uri="{0D108BD9-81ED-4DB2-BD59-A6C34878D82A}">
                    <a16:rowId xmlns:a16="http://schemas.microsoft.com/office/drawing/2014/main" val="382651471"/>
                  </a:ext>
                </a:extLst>
              </a:tr>
              <a:tr h="152399"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highlight>
                            <a:srgbClr val="FFFF00"/>
                          </a:highlight>
                        </a:rPr>
                        <a:t>PTV (mean, range)[cm³]</a:t>
                      </a:r>
                      <a:endParaRPr lang="de-DE" sz="800">
                        <a:effectLst/>
                        <a:highlight>
                          <a:srgbClr val="FFFF00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de-DE" sz="800" dirty="0">
                        <a:effectLst/>
                        <a:highlight>
                          <a:srgbClr val="FFFF00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highlight>
                            <a:srgbClr val="FFFF00"/>
                          </a:highlight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765.4 ()47.7-2983.7)</a:t>
                      </a: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b="1" dirty="0">
                          <a:effectLst/>
                          <a:highlight>
                            <a:srgbClr val="FFFF00"/>
                          </a:highlight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814.8 (81-2984)</a:t>
                      </a: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b="1" dirty="0">
                          <a:effectLst/>
                          <a:highlight>
                            <a:srgbClr val="FFFF00"/>
                          </a:highlight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00.4 (47.7-1025.4)</a:t>
                      </a: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b="1" dirty="0">
                          <a:effectLst/>
                          <a:highlight>
                            <a:srgbClr val="FFFF00"/>
                          </a:highlight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809 (462-1486)</a:t>
                      </a:r>
                    </a:p>
                  </a:txBody>
                  <a:tcPr marL="49606" marR="49606" marT="0" marB="0"/>
                </a:tc>
                <a:extLst>
                  <a:ext uri="{0D108BD9-81ED-4DB2-BD59-A6C34878D82A}">
                    <a16:rowId xmlns:a16="http://schemas.microsoft.com/office/drawing/2014/main" val="1768498602"/>
                  </a:ext>
                </a:extLst>
              </a:tr>
              <a:tr h="152399"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highlight>
                            <a:srgbClr val="FFFF00"/>
                          </a:highlight>
                        </a:rPr>
                        <a:t>GTV (mean, range)[cm³]</a:t>
                      </a:r>
                      <a:endParaRPr lang="de-DE" sz="800">
                        <a:effectLst/>
                        <a:highlight>
                          <a:srgbClr val="FFFF00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de-DE" sz="800" dirty="0">
                        <a:effectLst/>
                        <a:highlight>
                          <a:srgbClr val="FFFF00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highlight>
                            <a:srgbClr val="FFFF00"/>
                          </a:highlight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64.1 (3.3-289.2)</a:t>
                      </a: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800" b="1" dirty="0">
                          <a:effectLst/>
                          <a:highlight>
                            <a:srgbClr val="FFFF00"/>
                          </a:highlight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78.6 (5.9-289.2)</a:t>
                      </a: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b="1" dirty="0">
                          <a:effectLst/>
                          <a:highlight>
                            <a:srgbClr val="FFFF00"/>
                          </a:highlight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7.4 (3.3-63.4)</a:t>
                      </a: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b="1" dirty="0">
                          <a:effectLst/>
                          <a:highlight>
                            <a:srgbClr val="FFFF00"/>
                          </a:highlight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7.5 (3.7-79.8)</a:t>
                      </a:r>
                    </a:p>
                  </a:txBody>
                  <a:tcPr marL="49606" marR="49606" marT="0" marB="0"/>
                </a:tc>
                <a:extLst>
                  <a:ext uri="{0D108BD9-81ED-4DB2-BD59-A6C34878D82A}">
                    <a16:rowId xmlns:a16="http://schemas.microsoft.com/office/drawing/2014/main" val="3473934400"/>
                  </a:ext>
                </a:extLst>
              </a:tr>
              <a:tr h="152399"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</a:rPr>
                        <a:t>Systemic therapy (n, %)</a:t>
                      </a: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</a:rPr>
                        <a:t> </a:t>
                      </a: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0 (76.9)</a:t>
                      </a: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3 (76.5)</a:t>
                      </a: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 (75)</a:t>
                      </a: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 (80)</a:t>
                      </a:r>
                    </a:p>
                  </a:txBody>
                  <a:tcPr marL="49606" marR="49606" marT="0" marB="0"/>
                </a:tc>
                <a:extLst>
                  <a:ext uri="{0D108BD9-81ED-4DB2-BD59-A6C34878D82A}">
                    <a16:rowId xmlns:a16="http://schemas.microsoft.com/office/drawing/2014/main" val="4074111683"/>
                  </a:ext>
                </a:extLst>
              </a:tr>
              <a:tr h="152399"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</a:rPr>
                        <a:t> </a:t>
                      </a: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</a:rPr>
                        <a:t>Chemotherapy</a:t>
                      </a: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de-DE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de-DE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de-DE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extLst>
                  <a:ext uri="{0D108BD9-81ED-4DB2-BD59-A6C34878D82A}">
                    <a16:rowId xmlns:a16="http://schemas.microsoft.com/office/drawing/2014/main" val="2272893665"/>
                  </a:ext>
                </a:extLst>
              </a:tr>
              <a:tr h="152399"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</a:rPr>
                        <a:t> </a:t>
                      </a: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</a:rPr>
                        <a:t>         Neoadjuvant</a:t>
                      </a: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 (3.8)</a:t>
                      </a: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 (5.9)</a:t>
                      </a: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de-DE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extLst>
                  <a:ext uri="{0D108BD9-81ED-4DB2-BD59-A6C34878D82A}">
                    <a16:rowId xmlns:a16="http://schemas.microsoft.com/office/drawing/2014/main" val="2493323754"/>
                  </a:ext>
                </a:extLst>
              </a:tr>
              <a:tr h="152399"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</a:rPr>
                        <a:t> </a:t>
                      </a: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</a:rPr>
                        <a:t>         Concurrent</a:t>
                      </a: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9 (73.1)</a:t>
                      </a: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2 (70.6)</a:t>
                      </a: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 (75)</a:t>
                      </a: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 (80)</a:t>
                      </a:r>
                    </a:p>
                  </a:txBody>
                  <a:tcPr marL="49606" marR="49606" marT="0" marB="0"/>
                </a:tc>
                <a:extLst>
                  <a:ext uri="{0D108BD9-81ED-4DB2-BD59-A6C34878D82A}">
                    <a16:rowId xmlns:a16="http://schemas.microsoft.com/office/drawing/2014/main" val="901982610"/>
                  </a:ext>
                </a:extLst>
              </a:tr>
              <a:tr h="152399"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</a:rPr>
                        <a:t> </a:t>
                      </a: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</a:rPr>
                        <a:t>         adjuvant</a:t>
                      </a: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de-DE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extLst>
                  <a:ext uri="{0D108BD9-81ED-4DB2-BD59-A6C34878D82A}">
                    <a16:rowId xmlns:a16="http://schemas.microsoft.com/office/drawing/2014/main" val="1943928180"/>
                  </a:ext>
                </a:extLst>
              </a:tr>
              <a:tr h="152399"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</a:rPr>
                        <a:t> </a:t>
                      </a: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</a:rPr>
                        <a:t>Immunotherapy</a:t>
                      </a: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de-DE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extLst>
                  <a:ext uri="{0D108BD9-81ED-4DB2-BD59-A6C34878D82A}">
                    <a16:rowId xmlns:a16="http://schemas.microsoft.com/office/drawing/2014/main" val="181641762"/>
                  </a:ext>
                </a:extLst>
              </a:tr>
              <a:tr h="152399"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</a:rPr>
                        <a:t> </a:t>
                      </a:r>
                      <a:endParaRPr lang="de-DE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</a:rPr>
                        <a:t>         Neoadjuvant</a:t>
                      </a: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de-DE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de-DE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extLst>
                  <a:ext uri="{0D108BD9-81ED-4DB2-BD59-A6C34878D82A}">
                    <a16:rowId xmlns:a16="http://schemas.microsoft.com/office/drawing/2014/main" val="1771994644"/>
                  </a:ext>
                </a:extLst>
              </a:tr>
              <a:tr h="152399"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</a:rPr>
                        <a:t> </a:t>
                      </a: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</a:rPr>
                        <a:t>         Concurrent</a:t>
                      </a: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de-DE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extLst>
                  <a:ext uri="{0D108BD9-81ED-4DB2-BD59-A6C34878D82A}">
                    <a16:rowId xmlns:a16="http://schemas.microsoft.com/office/drawing/2014/main" val="609120469"/>
                  </a:ext>
                </a:extLst>
              </a:tr>
              <a:tr h="152399"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</a:rPr>
                        <a:t> </a:t>
                      </a: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</a:rPr>
                        <a:t>         adjuvant</a:t>
                      </a: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de-DE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extLst>
                  <a:ext uri="{0D108BD9-81ED-4DB2-BD59-A6C34878D82A}">
                    <a16:rowId xmlns:a16="http://schemas.microsoft.com/office/drawing/2014/main" val="1998636932"/>
                  </a:ext>
                </a:extLst>
              </a:tr>
              <a:tr h="152399"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</a:rPr>
                        <a:t> </a:t>
                      </a: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</a:rPr>
                        <a:t>Others </a:t>
                      </a: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de-DE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extLst>
                  <a:ext uri="{0D108BD9-81ED-4DB2-BD59-A6C34878D82A}">
                    <a16:rowId xmlns:a16="http://schemas.microsoft.com/office/drawing/2014/main" val="4149020055"/>
                  </a:ext>
                </a:extLst>
              </a:tr>
              <a:tr h="152399"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</a:rPr>
                        <a:t>Nicotine (n, %)</a:t>
                      </a: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</a:rPr>
                        <a:t> </a:t>
                      </a: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extLst>
                  <a:ext uri="{0D108BD9-81ED-4DB2-BD59-A6C34878D82A}">
                    <a16:rowId xmlns:a16="http://schemas.microsoft.com/office/drawing/2014/main" val="71919338"/>
                  </a:ext>
                </a:extLst>
              </a:tr>
              <a:tr h="152399"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</a:rPr>
                        <a:t> </a:t>
                      </a: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  <a:highlight>
                            <a:srgbClr val="FFFF00"/>
                          </a:highlight>
                        </a:rPr>
                        <a:t>Current smoker</a:t>
                      </a:r>
                      <a:endParaRPr lang="de-DE" sz="800">
                        <a:effectLst/>
                        <a:highlight>
                          <a:srgbClr val="FFFF00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highlight>
                            <a:srgbClr val="FFFF00"/>
                          </a:highlight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6 (61.5)</a:t>
                      </a: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highlight>
                            <a:srgbClr val="FFFF00"/>
                          </a:highlight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1 (64.7)</a:t>
                      </a: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highlight>
                            <a:srgbClr val="FFFF00"/>
                          </a:highlight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 (25)</a:t>
                      </a: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highlight>
                            <a:srgbClr val="FFFF00"/>
                          </a:highlight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 (80)</a:t>
                      </a:r>
                    </a:p>
                  </a:txBody>
                  <a:tcPr marL="49606" marR="49606" marT="0" marB="0"/>
                </a:tc>
                <a:extLst>
                  <a:ext uri="{0D108BD9-81ED-4DB2-BD59-A6C34878D82A}">
                    <a16:rowId xmlns:a16="http://schemas.microsoft.com/office/drawing/2014/main" val="54073196"/>
                  </a:ext>
                </a:extLst>
              </a:tr>
              <a:tr h="152399"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</a:rPr>
                        <a:t> </a:t>
                      </a: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</a:rPr>
                        <a:t>Former smoker</a:t>
                      </a: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 (11.5)</a:t>
                      </a: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 (11.8)</a:t>
                      </a: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de-DE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 (20)</a:t>
                      </a:r>
                    </a:p>
                  </a:txBody>
                  <a:tcPr marL="49606" marR="49606" marT="0" marB="0"/>
                </a:tc>
                <a:extLst>
                  <a:ext uri="{0D108BD9-81ED-4DB2-BD59-A6C34878D82A}">
                    <a16:rowId xmlns:a16="http://schemas.microsoft.com/office/drawing/2014/main" val="528186172"/>
                  </a:ext>
                </a:extLst>
              </a:tr>
              <a:tr h="152399"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</a:rPr>
                        <a:t> </a:t>
                      </a: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</a:rPr>
                        <a:t>Never smoker</a:t>
                      </a: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 (11.5)</a:t>
                      </a: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 (11.8)</a:t>
                      </a: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 (25)</a:t>
                      </a: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extLst>
                  <a:ext uri="{0D108BD9-81ED-4DB2-BD59-A6C34878D82A}">
                    <a16:rowId xmlns:a16="http://schemas.microsoft.com/office/drawing/2014/main" val="490968847"/>
                  </a:ext>
                </a:extLst>
              </a:tr>
              <a:tr h="152399"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</a:rPr>
                        <a:t> </a:t>
                      </a: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</a:rPr>
                        <a:t>NA</a:t>
                      </a: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 (15.4)</a:t>
                      </a: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 (11.8)</a:t>
                      </a: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 (50)</a:t>
                      </a: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extLst>
                  <a:ext uri="{0D108BD9-81ED-4DB2-BD59-A6C34878D82A}">
                    <a16:rowId xmlns:a16="http://schemas.microsoft.com/office/drawing/2014/main" val="2052292681"/>
                  </a:ext>
                </a:extLst>
              </a:tr>
              <a:tr h="152399"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</a:rPr>
                        <a:t>Pack years (mean, range)</a:t>
                      </a: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</a:rPr>
                        <a:t>n=89</a:t>
                      </a: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de-DE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de-DE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extLst>
                  <a:ext uri="{0D108BD9-81ED-4DB2-BD59-A6C34878D82A}">
                    <a16:rowId xmlns:a16="http://schemas.microsoft.com/office/drawing/2014/main" val="3591221406"/>
                  </a:ext>
                </a:extLst>
              </a:tr>
              <a:tr h="152399"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</a:rPr>
                        <a:t>Alcohol abuse (n, %)</a:t>
                      </a: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</a:rPr>
                        <a:t> </a:t>
                      </a: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de-DE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extLst>
                  <a:ext uri="{0D108BD9-81ED-4DB2-BD59-A6C34878D82A}">
                    <a16:rowId xmlns:a16="http://schemas.microsoft.com/office/drawing/2014/main" val="510411440"/>
                  </a:ext>
                </a:extLst>
              </a:tr>
              <a:tr h="152399"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</a:rPr>
                        <a:t> </a:t>
                      </a: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  <a:highlight>
                            <a:srgbClr val="FFFF00"/>
                          </a:highlight>
                        </a:rPr>
                        <a:t>Current </a:t>
                      </a:r>
                      <a:endParaRPr lang="de-DE" sz="800">
                        <a:effectLst/>
                        <a:highlight>
                          <a:srgbClr val="FFFF00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highlight>
                            <a:srgbClr val="FFFF00"/>
                          </a:highlight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9 (34.6)</a:t>
                      </a: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highlight>
                            <a:srgbClr val="FFFF00"/>
                          </a:highlight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 (23.5)</a:t>
                      </a: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highlight>
                            <a:srgbClr val="FFFF00"/>
                          </a:highlight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 (25)</a:t>
                      </a: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highlight>
                            <a:srgbClr val="FFFF00"/>
                          </a:highlight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 (80)</a:t>
                      </a:r>
                    </a:p>
                  </a:txBody>
                  <a:tcPr marL="49606" marR="49606" marT="0" marB="0"/>
                </a:tc>
                <a:extLst>
                  <a:ext uri="{0D108BD9-81ED-4DB2-BD59-A6C34878D82A}">
                    <a16:rowId xmlns:a16="http://schemas.microsoft.com/office/drawing/2014/main" val="3772457140"/>
                  </a:ext>
                </a:extLst>
              </a:tr>
              <a:tr h="152399"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</a:rPr>
                        <a:t> </a:t>
                      </a: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</a:rPr>
                        <a:t>Former</a:t>
                      </a: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(7.7)</a:t>
                      </a: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 (5.9)</a:t>
                      </a: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 (25)</a:t>
                      </a: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de-DE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extLst>
                  <a:ext uri="{0D108BD9-81ED-4DB2-BD59-A6C34878D82A}">
                    <a16:rowId xmlns:a16="http://schemas.microsoft.com/office/drawing/2014/main" val="256637067"/>
                  </a:ext>
                </a:extLst>
              </a:tr>
              <a:tr h="152399"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</a:rPr>
                        <a:t> </a:t>
                      </a: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</a:rPr>
                        <a:t>Never</a:t>
                      </a:r>
                      <a:endParaRPr lang="de-DE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2 (46.2)</a:t>
                      </a: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0 (58.8)</a:t>
                      </a: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 (25)</a:t>
                      </a: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 (20)</a:t>
                      </a:r>
                    </a:p>
                  </a:txBody>
                  <a:tcPr marL="49606" marR="49606" marT="0" marB="0"/>
                </a:tc>
                <a:extLst>
                  <a:ext uri="{0D108BD9-81ED-4DB2-BD59-A6C34878D82A}">
                    <a16:rowId xmlns:a16="http://schemas.microsoft.com/office/drawing/2014/main" val="3151108625"/>
                  </a:ext>
                </a:extLst>
              </a:tr>
              <a:tr h="152399"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>
                          <a:effectLst/>
                        </a:rPr>
                        <a:t> </a:t>
                      </a:r>
                      <a:endParaRPr lang="de-DE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</a:rPr>
                        <a:t>NA</a:t>
                      </a:r>
                      <a:endParaRPr lang="de-DE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 (11.5)</a:t>
                      </a: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 (11.8)</a:t>
                      </a: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 (25)</a:t>
                      </a: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de-DE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extLst>
                  <a:ext uri="{0D108BD9-81ED-4DB2-BD59-A6C34878D82A}">
                    <a16:rowId xmlns:a16="http://schemas.microsoft.com/office/drawing/2014/main" val="2841424248"/>
                  </a:ext>
                </a:extLst>
              </a:tr>
              <a:tr h="152399"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Iron </a:t>
                      </a:r>
                      <a:r>
                        <a:rPr lang="de-DE" sz="800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supplementation</a:t>
                      </a: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(n%)</a:t>
                      </a: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de-DE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4 (53.8)</a:t>
                      </a: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9 (52.9)</a:t>
                      </a: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 (50)</a:t>
                      </a:r>
                    </a:p>
                  </a:txBody>
                  <a:tcPr marL="49606" marR="49606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 (60)</a:t>
                      </a:r>
                    </a:p>
                  </a:txBody>
                  <a:tcPr marL="49606" marR="49606" marT="0" marB="0"/>
                </a:tc>
                <a:extLst>
                  <a:ext uri="{0D108BD9-81ED-4DB2-BD59-A6C34878D82A}">
                    <a16:rowId xmlns:a16="http://schemas.microsoft.com/office/drawing/2014/main" val="1661530310"/>
                  </a:ext>
                </a:extLst>
              </a:tr>
            </a:tbl>
          </a:graphicData>
        </a:graphic>
      </p:graphicFrame>
      <p:sp>
        <p:nvSpPr>
          <p:cNvPr id="3" name="Rechteck 2">
            <a:extLst>
              <a:ext uri="{FF2B5EF4-FFF2-40B4-BE49-F238E27FC236}">
                <a16:creationId xmlns:a16="http://schemas.microsoft.com/office/drawing/2014/main" id="{8765345B-0A20-4049-AD25-5F0A7FEEC690}"/>
              </a:ext>
            </a:extLst>
          </p:cNvPr>
          <p:cNvSpPr/>
          <p:nvPr/>
        </p:nvSpPr>
        <p:spPr>
          <a:xfrm>
            <a:off x="336551" y="323990"/>
            <a:ext cx="6521449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1000"/>
              </a:spcAft>
            </a:pPr>
            <a:r>
              <a:rPr lang="en-US" sz="1200" i="1" dirty="0" err="1">
                <a:solidFill>
                  <a:srgbClr val="44546A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.Table</a:t>
            </a:r>
            <a:r>
              <a:rPr lang="en-US" sz="1200" i="1" dirty="0">
                <a:solidFill>
                  <a:srgbClr val="44546A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4: Patient characteristics of matched samples (BL to RTE); n=number of patients, BMI= body mass index, </a:t>
            </a:r>
            <a:r>
              <a:rPr lang="en-US" sz="1200" i="1" dirty="0" err="1">
                <a:solidFill>
                  <a:srgbClr val="44546A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x</a:t>
            </a:r>
            <a:r>
              <a:rPr lang="en-US" sz="1200" i="1" dirty="0">
                <a:solidFill>
                  <a:srgbClr val="44546A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= Fraction, KI= </a:t>
            </a:r>
            <a:r>
              <a:rPr lang="en-US" sz="1200" i="1" dirty="0" err="1">
                <a:solidFill>
                  <a:srgbClr val="44546A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arnofsky</a:t>
            </a:r>
            <a:r>
              <a:rPr lang="en-US" sz="1200" i="1" dirty="0">
                <a:solidFill>
                  <a:srgbClr val="44546A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Index, RT= radiotherapy, NA= not available</a:t>
            </a:r>
            <a:endParaRPr lang="de-DE" sz="1000" i="1" dirty="0">
              <a:solidFill>
                <a:srgbClr val="44546A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7081186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feld 5">
            <a:extLst>
              <a:ext uri="{FF2B5EF4-FFF2-40B4-BE49-F238E27FC236}">
                <a16:creationId xmlns:a16="http://schemas.microsoft.com/office/drawing/2014/main" id="{8F73E4F2-42BA-238B-C029-032931B68719}"/>
              </a:ext>
            </a:extLst>
          </p:cNvPr>
          <p:cNvSpPr txBox="1"/>
          <p:nvPr/>
        </p:nvSpPr>
        <p:spPr>
          <a:xfrm>
            <a:off x="523875" y="3545867"/>
            <a:ext cx="5433172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err="1"/>
              <a:t>Suppl</a:t>
            </a:r>
            <a:r>
              <a:rPr lang="de-DE" sz="1200" dirty="0"/>
              <a:t>. Fig. 1: Time </a:t>
            </a:r>
            <a:r>
              <a:rPr lang="de-DE" sz="1200" dirty="0" err="1"/>
              <a:t>points</a:t>
            </a:r>
            <a:r>
              <a:rPr lang="de-DE" sz="1200" dirty="0"/>
              <a:t> </a:t>
            </a:r>
            <a:r>
              <a:rPr lang="de-DE" sz="1200" dirty="0" err="1"/>
              <a:t>of</a:t>
            </a:r>
            <a:r>
              <a:rPr lang="de-DE" sz="1200" dirty="0"/>
              <a:t> </a:t>
            </a:r>
            <a:r>
              <a:rPr lang="de-DE" sz="1200" dirty="0" err="1"/>
              <a:t>blood</a:t>
            </a:r>
            <a:r>
              <a:rPr lang="de-DE" sz="1200" dirty="0"/>
              <a:t> </a:t>
            </a:r>
            <a:r>
              <a:rPr lang="de-DE" sz="1200" dirty="0" err="1"/>
              <a:t>sampling</a:t>
            </a:r>
            <a:r>
              <a:rPr lang="de-DE" sz="1200" dirty="0"/>
              <a:t> relative </a:t>
            </a:r>
            <a:r>
              <a:rPr lang="de-DE" sz="1200" dirty="0" err="1"/>
              <a:t>to</a:t>
            </a:r>
            <a:r>
              <a:rPr lang="de-DE" sz="1200" dirty="0"/>
              <a:t> date </a:t>
            </a:r>
            <a:r>
              <a:rPr lang="de-DE" sz="1200" dirty="0" err="1"/>
              <a:t>of</a:t>
            </a:r>
            <a:r>
              <a:rPr lang="de-DE" sz="1200" dirty="0"/>
              <a:t> </a:t>
            </a:r>
            <a:r>
              <a:rPr lang="de-DE" sz="1200" dirty="0" err="1"/>
              <a:t>first</a:t>
            </a:r>
            <a:r>
              <a:rPr lang="de-DE" sz="1200" dirty="0"/>
              <a:t>  </a:t>
            </a:r>
            <a:r>
              <a:rPr lang="de-DE" sz="1200" dirty="0" err="1"/>
              <a:t>day</a:t>
            </a:r>
            <a:r>
              <a:rPr lang="de-DE" sz="1200" dirty="0"/>
              <a:t> </a:t>
            </a:r>
            <a:r>
              <a:rPr lang="de-DE" sz="1200" dirty="0" err="1"/>
              <a:t>or</a:t>
            </a:r>
            <a:r>
              <a:rPr lang="de-DE" sz="1200" dirty="0"/>
              <a:t> last </a:t>
            </a:r>
            <a:r>
              <a:rPr lang="de-DE" sz="1200" dirty="0" err="1"/>
              <a:t>day</a:t>
            </a:r>
            <a:r>
              <a:rPr lang="de-DE" sz="1200" dirty="0"/>
              <a:t> </a:t>
            </a:r>
            <a:r>
              <a:rPr lang="de-DE" sz="1200" dirty="0" err="1"/>
              <a:t>of</a:t>
            </a:r>
            <a:r>
              <a:rPr lang="de-DE" sz="1200" dirty="0"/>
              <a:t> RT (A). Irradiation dose at different time </a:t>
            </a:r>
            <a:r>
              <a:rPr lang="de-DE" sz="1200" dirty="0" err="1"/>
              <a:t>points</a:t>
            </a:r>
            <a:r>
              <a:rPr lang="de-DE" sz="1200" dirty="0"/>
              <a:t> (B). </a:t>
            </a:r>
            <a:r>
              <a:rPr lang="de-DE" sz="1200" dirty="0" err="1"/>
              <a:t>Shown</a:t>
            </a:r>
            <a:r>
              <a:rPr lang="de-DE" sz="1200" dirty="0"/>
              <a:t> </a:t>
            </a:r>
            <a:r>
              <a:rPr lang="de-DE" sz="1200" dirty="0" err="1"/>
              <a:t>are</a:t>
            </a:r>
            <a:r>
              <a:rPr lang="de-DE" sz="1200" dirty="0"/>
              <a:t> median and 25 and 75 </a:t>
            </a:r>
            <a:r>
              <a:rPr lang="de-DE" sz="1200" dirty="0" err="1"/>
              <a:t>quartiles</a:t>
            </a:r>
            <a:r>
              <a:rPr lang="de-DE" sz="1200" dirty="0"/>
              <a:t>. </a:t>
            </a:r>
            <a:r>
              <a:rPr lang="de-DE" sz="1200" dirty="0" err="1"/>
              <a:t>ns</a:t>
            </a:r>
            <a:r>
              <a:rPr lang="de-DE" sz="1200" dirty="0"/>
              <a:t>= p&gt;.05, *=p≤.05, **=p≤.01, ***=p≤.001, ****= p ≤.0001. BL= </a:t>
            </a:r>
            <a:r>
              <a:rPr lang="de-DE" sz="1200" dirty="0" err="1"/>
              <a:t>baseline</a:t>
            </a:r>
            <a:r>
              <a:rPr lang="de-DE" sz="1200" dirty="0"/>
              <a:t>, FU= follow </a:t>
            </a:r>
            <a:r>
              <a:rPr lang="de-DE" sz="1200" dirty="0" err="1"/>
              <a:t>up</a:t>
            </a:r>
            <a:r>
              <a:rPr lang="de-DE" sz="1200" dirty="0"/>
              <a:t>, RT=</a:t>
            </a:r>
            <a:r>
              <a:rPr lang="de-DE" sz="1200" dirty="0" err="1"/>
              <a:t>radiotherapy</a:t>
            </a:r>
            <a:r>
              <a:rPr lang="de-DE" sz="1200" dirty="0"/>
              <a:t>, EOT= End </a:t>
            </a:r>
            <a:r>
              <a:rPr lang="de-DE" sz="1200" dirty="0" err="1"/>
              <a:t>of</a:t>
            </a:r>
            <a:r>
              <a:rPr lang="de-DE" sz="1200" dirty="0"/>
              <a:t> </a:t>
            </a:r>
            <a:r>
              <a:rPr lang="de-DE" sz="1200"/>
              <a:t>Radiotherap</a:t>
            </a:r>
            <a:r>
              <a:rPr lang="de-DE" sz="1200" dirty="0"/>
              <a:t>y</a:t>
            </a:r>
            <a:r>
              <a:rPr lang="de-DE" sz="1200"/>
              <a:t>. </a:t>
            </a:r>
            <a:endParaRPr lang="de-DE" sz="1200" dirty="0"/>
          </a:p>
        </p:txBody>
      </p:sp>
      <p:pic>
        <p:nvPicPr>
          <p:cNvPr id="8" name="Grafik 7">
            <a:extLst>
              <a:ext uri="{FF2B5EF4-FFF2-40B4-BE49-F238E27FC236}">
                <a16:creationId xmlns:a16="http://schemas.microsoft.com/office/drawing/2014/main" id="{FA7E9082-65EA-4D45-9340-8D76A6369D7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417633" y="266816"/>
            <a:ext cx="5645655" cy="327905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2180698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feld 4">
            <a:extLst>
              <a:ext uri="{FF2B5EF4-FFF2-40B4-BE49-F238E27FC236}">
                <a16:creationId xmlns:a16="http://schemas.microsoft.com/office/drawing/2014/main" id="{ADA54BF5-FB99-82E6-2400-02FBF3781702}"/>
              </a:ext>
            </a:extLst>
          </p:cNvPr>
          <p:cNvSpPr txBox="1"/>
          <p:nvPr/>
        </p:nvSpPr>
        <p:spPr>
          <a:xfrm>
            <a:off x="383766" y="5114027"/>
            <a:ext cx="5433172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err="1"/>
              <a:t>Suppl</a:t>
            </a:r>
            <a:r>
              <a:rPr lang="de-DE" sz="1200" dirty="0"/>
              <a:t>. Fig. 2: Individual </a:t>
            </a:r>
            <a:r>
              <a:rPr lang="de-DE" sz="1200" dirty="0" err="1"/>
              <a:t>values</a:t>
            </a:r>
            <a:r>
              <a:rPr lang="de-DE" sz="1200" dirty="0"/>
              <a:t> and </a:t>
            </a:r>
            <a:r>
              <a:rPr lang="de-DE" sz="1200" dirty="0" err="1"/>
              <a:t>courses</a:t>
            </a:r>
            <a:r>
              <a:rPr lang="de-DE" sz="1200" dirty="0"/>
              <a:t> </a:t>
            </a:r>
            <a:r>
              <a:rPr lang="de-DE" sz="1200" dirty="0" err="1"/>
              <a:t>of</a:t>
            </a:r>
            <a:r>
              <a:rPr lang="de-DE" sz="1200" dirty="0"/>
              <a:t> </a:t>
            </a:r>
            <a:r>
              <a:rPr lang="de-DE" sz="1200" dirty="0" err="1"/>
              <a:t>transferrin</a:t>
            </a:r>
            <a:r>
              <a:rPr lang="de-DE" sz="1200" dirty="0"/>
              <a:t> </a:t>
            </a:r>
            <a:r>
              <a:rPr lang="de-DE" sz="1200" dirty="0" err="1"/>
              <a:t>saturation</a:t>
            </a:r>
            <a:r>
              <a:rPr lang="de-DE" sz="1200" dirty="0"/>
              <a:t> </a:t>
            </a:r>
            <a:r>
              <a:rPr lang="de-DE" sz="1200" dirty="0" err="1"/>
              <a:t>for</a:t>
            </a:r>
            <a:r>
              <a:rPr lang="de-DE" sz="1200" dirty="0"/>
              <a:t> </a:t>
            </a:r>
            <a:r>
              <a:rPr lang="de-DE" sz="1200" dirty="0" err="1"/>
              <a:t>patients</a:t>
            </a:r>
            <a:r>
              <a:rPr lang="de-DE" sz="1200" dirty="0"/>
              <a:t> at different time </a:t>
            </a:r>
            <a:r>
              <a:rPr lang="de-DE" sz="1200" dirty="0" err="1"/>
              <a:t>points</a:t>
            </a:r>
            <a:r>
              <a:rPr lang="de-DE" sz="1200" dirty="0"/>
              <a:t> </a:t>
            </a:r>
            <a:r>
              <a:rPr lang="de-DE" sz="1200" dirty="0" err="1"/>
              <a:t>with</a:t>
            </a:r>
            <a:r>
              <a:rPr lang="de-DE" sz="1200" dirty="0"/>
              <a:t> </a:t>
            </a:r>
            <a:r>
              <a:rPr lang="de-DE" sz="1200" dirty="0" err="1"/>
              <a:t>increase</a:t>
            </a:r>
            <a:r>
              <a:rPr lang="de-DE" sz="1200" dirty="0"/>
              <a:t> (A), </a:t>
            </a:r>
            <a:r>
              <a:rPr lang="de-DE" sz="1200" dirty="0" err="1"/>
              <a:t>no</a:t>
            </a:r>
            <a:r>
              <a:rPr lang="de-DE" sz="1200" dirty="0"/>
              <a:t> </a:t>
            </a:r>
            <a:r>
              <a:rPr lang="de-DE" sz="1200" dirty="0" err="1"/>
              <a:t>changes</a:t>
            </a:r>
            <a:r>
              <a:rPr lang="de-DE" sz="1200" dirty="0"/>
              <a:t> (B) and </a:t>
            </a:r>
            <a:r>
              <a:rPr lang="de-DE" sz="1200" dirty="0" err="1"/>
              <a:t>decrease</a:t>
            </a:r>
            <a:r>
              <a:rPr lang="de-DE" sz="1200" dirty="0"/>
              <a:t> (C) </a:t>
            </a:r>
            <a:r>
              <a:rPr lang="de-DE" sz="1200" dirty="0" err="1"/>
              <a:t>between</a:t>
            </a:r>
            <a:r>
              <a:rPr lang="de-DE" sz="1200" dirty="0"/>
              <a:t> </a:t>
            </a:r>
            <a:r>
              <a:rPr lang="de-DE" sz="1200" dirty="0" err="1"/>
              <a:t>baseline</a:t>
            </a:r>
            <a:r>
              <a:rPr lang="de-DE" sz="1200" dirty="0"/>
              <a:t> and end </a:t>
            </a:r>
            <a:r>
              <a:rPr lang="de-DE" sz="1200" dirty="0" err="1"/>
              <a:t>of</a:t>
            </a:r>
            <a:r>
              <a:rPr lang="de-DE" sz="1200" dirty="0"/>
              <a:t> </a:t>
            </a:r>
            <a:r>
              <a:rPr lang="de-DE" sz="1200" dirty="0" err="1"/>
              <a:t>treatment</a:t>
            </a:r>
            <a:r>
              <a:rPr lang="de-DE" sz="1200" dirty="0"/>
              <a:t>. BL= </a:t>
            </a:r>
            <a:r>
              <a:rPr lang="de-DE" sz="1200" dirty="0" err="1"/>
              <a:t>baseline</a:t>
            </a:r>
            <a:r>
              <a:rPr lang="de-DE" sz="1200" dirty="0"/>
              <a:t>, FU= follow </a:t>
            </a:r>
            <a:r>
              <a:rPr lang="de-DE" sz="1200" dirty="0" err="1"/>
              <a:t>up</a:t>
            </a:r>
            <a:r>
              <a:rPr lang="de-DE" sz="1200" dirty="0"/>
              <a:t>, RT=</a:t>
            </a:r>
            <a:r>
              <a:rPr lang="de-DE" sz="1200" dirty="0" err="1"/>
              <a:t>radiotherapy</a:t>
            </a:r>
            <a:r>
              <a:rPr lang="de-DE" sz="1200" dirty="0"/>
              <a:t>, EOT=End </a:t>
            </a:r>
            <a:r>
              <a:rPr lang="de-DE" sz="1200" dirty="0" err="1"/>
              <a:t>of</a:t>
            </a:r>
            <a:r>
              <a:rPr lang="de-DE" sz="1200" dirty="0"/>
              <a:t> </a:t>
            </a:r>
            <a:r>
              <a:rPr lang="de-DE" sz="1200" dirty="0" err="1"/>
              <a:t>Radiotherapy</a:t>
            </a:r>
            <a:r>
              <a:rPr lang="de-DE" sz="1200" dirty="0"/>
              <a:t>. </a:t>
            </a:r>
          </a:p>
        </p:txBody>
      </p:sp>
      <p:pic>
        <p:nvPicPr>
          <p:cNvPr id="11" name="Grafik 10">
            <a:extLst>
              <a:ext uri="{FF2B5EF4-FFF2-40B4-BE49-F238E27FC236}">
                <a16:creationId xmlns:a16="http://schemas.microsoft.com/office/drawing/2014/main" id="{C084F6C1-05B6-4FBC-A526-E08FA4F3299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297683" y="1736550"/>
            <a:ext cx="5424432" cy="337747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044998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509</Words>
  <Application>Microsoft Office PowerPoint</Application>
  <PresentationFormat>A4-Papier (210 x 297 mm)</PresentationFormat>
  <Paragraphs>565</Paragraphs>
  <Slides>6</Slides>
  <Notes>1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6</vt:i4>
      </vt:variant>
    </vt:vector>
  </HeadingPairs>
  <TitlesOfParts>
    <vt:vector size="11" baseType="lpstr">
      <vt:lpstr>Aptos</vt:lpstr>
      <vt:lpstr>Aptos Display</vt:lpstr>
      <vt:lpstr>Arial</vt:lpstr>
      <vt:lpstr>Calibri</vt:lpstr>
      <vt:lpstr>Office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Franziska Hauth</dc:creator>
  <cp:lastModifiedBy>Hausmann, Franziska</cp:lastModifiedBy>
  <cp:revision>74</cp:revision>
  <dcterms:created xsi:type="dcterms:W3CDTF">2024-07-31T15:21:28Z</dcterms:created>
  <dcterms:modified xsi:type="dcterms:W3CDTF">2026-01-20T10:54:31Z</dcterms:modified>
</cp:coreProperties>
</file>